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96" r:id="rId2"/>
    <p:sldId id="286" r:id="rId3"/>
    <p:sldId id="277" r:id="rId4"/>
    <p:sldId id="300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0219"/>
    <p:restoredTop sz="96835"/>
  </p:normalViewPr>
  <p:slideViewPr>
    <p:cSldViewPr snapToGrid="0" snapToObjects="1">
      <p:cViewPr>
        <p:scale>
          <a:sx n="180" d="100"/>
          <a:sy n="180" d="100"/>
        </p:scale>
        <p:origin x="1536" y="-4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Volumes/GoogleDrive/My%20Drive/BGKim/Papers/IFNg%20DKO/Memory-Treg%20population%20of%20IFNg-Smad4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H:\Sung%20Hee%20Choi\Case%20Western\experiments\results\Real_time%20PCR\2011-2-20-jackson\2011-12-20_Jacksons%20lab_Cytokine_2-17-samples_final.xls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GoogleDrive/My%20Drive/DropBox/DATA/Byung-Gyu%20Kim/Research/IFNg%20KO-Smad4%20DKO/06122017%20Tumor%20and%20T%20cell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GoogleDrive/My%20Drive/BGKim/Papers/VEGF%20in%20MOPC315/IHC%20score%20in%20VEGF%20MM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regsMemory in IFNgko'!$A$21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FFFFFF"/>
            </a:solidFill>
            <a:ln w="9525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regsMemory in IFNgko'!$AA$213:$AB$213</c:f>
                <c:numCache>
                  <c:formatCode>General</c:formatCode>
                  <c:ptCount val="2"/>
                  <c:pt idx="0">
                    <c:v>2.1</c:v>
                  </c:pt>
                  <c:pt idx="1">
                    <c:v>1.3</c:v>
                  </c:pt>
                </c:numCache>
              </c:numRef>
            </c:plus>
            <c:minus>
              <c:numRef>
                <c:f>'TregsMemory in IFNgko'!$N$213:$O$213</c:f>
                <c:numCache>
                  <c:formatCode>General</c:formatCode>
                  <c:ptCount val="2"/>
                  <c:pt idx="0">
                    <c:v>0.5</c:v>
                  </c:pt>
                  <c:pt idx="1">
                    <c:v>3</c:v>
                  </c:pt>
                </c:numCache>
              </c:numRef>
            </c:minus>
            <c:spPr>
              <a:ln w="9525">
                <a:solidFill>
                  <a:schemeClr val="tx1"/>
                </a:solidFill>
                <a:prstDash val="solid"/>
              </a:ln>
            </c:spPr>
          </c:errBars>
          <c:cat>
            <c:strRef>
              <c:f>'TregsMemory in IFNgko'!$AF$212:$AG$212</c:f>
              <c:strCache>
                <c:ptCount val="2"/>
                <c:pt idx="0">
                  <c:v>IFN-g</c:v>
                </c:pt>
                <c:pt idx="1">
                  <c:v>IL-6</c:v>
                </c:pt>
              </c:strCache>
            </c:strRef>
          </c:cat>
          <c:val>
            <c:numRef>
              <c:f>'TregsMemory in IFNgko'!$AF$213:$AG$213</c:f>
              <c:numCache>
                <c:formatCode>General</c:formatCode>
                <c:ptCount val="2"/>
                <c:pt idx="0">
                  <c:v>1.94</c:v>
                </c:pt>
                <c:pt idx="1">
                  <c:v>2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C7-7941-B0B6-6BE26B8BF8EC}"/>
            </c:ext>
          </c:extLst>
        </c:ser>
        <c:ser>
          <c:idx val="1"/>
          <c:order val="1"/>
          <c:tx>
            <c:strRef>
              <c:f>'TregsMemory in IFNgko'!$A$214</c:f>
              <c:strCache>
                <c:ptCount val="1"/>
                <c:pt idx="0">
                  <c:v>Smad4TKO</c:v>
                </c:pt>
              </c:strCache>
            </c:strRef>
          </c:tx>
          <c:spPr>
            <a:solidFill>
              <a:srgbClr val="000000"/>
            </a:solidFill>
            <a:ln w="9525">
              <a:solidFill>
                <a:srgbClr val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regsMemory in IFNgko'!$AA$214:$AB$214</c:f>
                <c:numCache>
                  <c:formatCode>General</c:formatCode>
                  <c:ptCount val="2"/>
                  <c:pt idx="0">
                    <c:v>1.5</c:v>
                  </c:pt>
                  <c:pt idx="1">
                    <c:v>2.1</c:v>
                  </c:pt>
                </c:numCache>
              </c:numRef>
            </c:plus>
            <c:minus>
              <c:numRef>
                <c:f>'TregsMemory in IFNgko'!$N$214:$O$214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1.5</c:v>
                  </c:pt>
                </c:numCache>
              </c:numRef>
            </c:minus>
            <c:spPr>
              <a:ln w="9525">
                <a:solidFill>
                  <a:schemeClr val="tx1"/>
                </a:solidFill>
                <a:prstDash val="solid"/>
              </a:ln>
            </c:spPr>
          </c:errBars>
          <c:cat>
            <c:strRef>
              <c:f>'TregsMemory in IFNgko'!$AF$212:$AG$212</c:f>
              <c:strCache>
                <c:ptCount val="2"/>
                <c:pt idx="0">
                  <c:v>IFN-g</c:v>
                </c:pt>
                <c:pt idx="1">
                  <c:v>IL-6</c:v>
                </c:pt>
              </c:strCache>
            </c:strRef>
          </c:cat>
          <c:val>
            <c:numRef>
              <c:f>'TregsMemory in IFNgko'!$AF$214:$AG$214</c:f>
              <c:numCache>
                <c:formatCode>General</c:formatCode>
                <c:ptCount val="2"/>
                <c:pt idx="0">
                  <c:v>12.6</c:v>
                </c:pt>
                <c:pt idx="1">
                  <c:v>14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C7-7941-B0B6-6BE26B8BF8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6"/>
        <c:axId val="2020051567"/>
        <c:axId val="1"/>
      </c:barChart>
      <c:catAx>
        <c:axId val="20200515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952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100" b="0" i="0" u="none" strike="noStrike" baseline="0">
                <a:solidFill>
                  <a:srgbClr val="333333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20"/>
        </c:scaling>
        <c:delete val="0"/>
        <c:axPos val="l"/>
        <c:minorGridlines>
          <c:spPr>
            <a:ln w="3175">
              <a:noFill/>
              <a:prstDash val="sysDot"/>
            </a:ln>
          </c:spPr>
        </c:minorGridlines>
        <c:title>
          <c:tx>
            <c:rich>
              <a:bodyPr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% IFN-</a:t>
                </a:r>
                <a:r>
                  <a:rPr lang="en-US" sz="1100" dirty="0">
                    <a:latin typeface="Symbol" pitchFamily="2" charset="2"/>
                    <a:cs typeface="Arial" panose="020B0604020202020204" pitchFamily="34" charset="0"/>
                  </a:rPr>
                  <a:t>g</a:t>
                </a:r>
                <a:r>
                  <a:rPr lang="en-US" sz="11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Producing 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c:rich>
          </c:tx>
          <c:layout>
            <c:manualLayout>
              <c:xMode val="edge"/>
              <c:yMode val="edge"/>
              <c:x val="4.8512941183007342E-2"/>
              <c:y val="0.1790969220001895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952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333333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2020051567"/>
        <c:crosses val="autoZero"/>
        <c:crossBetween val="between"/>
        <c:majorUnit val="5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1683076414871558"/>
          <c:y val="0.12730831759825614"/>
          <c:w val="0.49955068275745662"/>
          <c:h val="9.2295796365014907E-2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900" b="0" i="0" u="none" strike="noStrike" baseline="0">
              <a:solidFill>
                <a:srgbClr val="333333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9262729658792699"/>
          <c:y val="5.1400554097404502E-2"/>
          <c:w val="0.70555052493438297"/>
          <c:h val="0.897198891805190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C$29:$E$29</c:f>
                <c:numCache>
                  <c:formatCode>General</c:formatCode>
                  <c:ptCount val="3"/>
                  <c:pt idx="0">
                    <c:v>0.35551043872064497</c:v>
                  </c:pt>
                  <c:pt idx="1">
                    <c:v>0.33064433453634301</c:v>
                  </c:pt>
                  <c:pt idx="2">
                    <c:v>0.32635488609010099</c:v>
                  </c:pt>
                </c:numCache>
              </c:numRef>
            </c:plus>
          </c:errBars>
          <c:val>
            <c:numRef>
              <c:f>Sheet1!$C$25:$E$25</c:f>
              <c:numCache>
                <c:formatCode>0.00000000000000</c:formatCode>
                <c:ptCount val="3"/>
                <c:pt idx="0">
                  <c:v>1.1937131542236319</c:v>
                </c:pt>
                <c:pt idx="1">
                  <c:v>1.147893570239449</c:v>
                </c:pt>
                <c:pt idx="2">
                  <c:v>1.11254883387081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54-854A-8ECF-C88ACC7CAE61}"/>
            </c:ext>
          </c:extLst>
        </c:ser>
        <c:ser>
          <c:idx val="1"/>
          <c:order val="1"/>
          <c:tx>
            <c:strRef>
              <c:f>Sheet1!$B$26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chemeClr val="tx1">
                  <a:alpha val="88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solidFill>
                  <a:sysClr val="windowText" lastClr="000000">
                    <a:alpha val="88000"/>
                  </a:sys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DD4-164C-9114-FBC87BE5DEB7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C$30:$E$30</c:f>
                <c:numCache>
                  <c:formatCode>General</c:formatCode>
                  <c:ptCount val="3"/>
                  <c:pt idx="0">
                    <c:v>0.17468911680382701</c:v>
                  </c:pt>
                  <c:pt idx="1">
                    <c:v>0.16981854969712801</c:v>
                  </c:pt>
                  <c:pt idx="2">
                    <c:v>0.208368293437486</c:v>
                  </c:pt>
                </c:numCache>
              </c:numRef>
            </c:plus>
            <c:spPr>
              <a:noFill/>
              <a:ln>
                <a:solidFill>
                  <a:schemeClr val="tx1">
                    <a:alpha val="88000"/>
                  </a:schemeClr>
                </a:solidFill>
              </a:ln>
            </c:spPr>
          </c:errBars>
          <c:val>
            <c:numRef>
              <c:f>Sheet1!$C$26:$E$26</c:f>
              <c:numCache>
                <c:formatCode>0.00000000000000</c:formatCode>
                <c:ptCount val="3"/>
                <c:pt idx="0">
                  <c:v>7.2996273998126204</c:v>
                </c:pt>
                <c:pt idx="1">
                  <c:v>1.7020489615785881</c:v>
                </c:pt>
                <c:pt idx="2">
                  <c:v>9.90784129235225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54-854A-8ECF-C88ACC7CAE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13839136"/>
        <c:axId val="-2013834976"/>
      </c:barChart>
      <c:catAx>
        <c:axId val="-201383913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>
            <a:solidFill>
              <a:sysClr val="windowText" lastClr="000000"/>
            </a:solidFill>
          </a:ln>
        </c:spPr>
        <c:crossAx val="-2013834976"/>
        <c:crosses val="autoZero"/>
        <c:auto val="1"/>
        <c:lblAlgn val="ctr"/>
        <c:lblOffset val="100"/>
        <c:noMultiLvlLbl val="0"/>
      </c:catAx>
      <c:valAx>
        <c:axId val="-201383497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0"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 sz="1200" b="0">
                    <a:latin typeface="Arial" charset="0"/>
                    <a:ea typeface="Arial" charset="0"/>
                    <a:cs typeface="Arial" charset="0"/>
                  </a:rPr>
                  <a:t>mRNA relative expression </a:t>
                </a:r>
              </a:p>
            </c:rich>
          </c:tx>
          <c:overlay val="0"/>
        </c:title>
        <c:numFmt formatCode="0" sourceLinked="0"/>
        <c:majorTickMark val="out"/>
        <c:minorTickMark val="out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900"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2013839136"/>
        <c:crosses val="autoZero"/>
        <c:crossBetween val="between"/>
        <c:minorUnit val="1"/>
      </c:valAx>
    </c:plotArea>
    <c:legend>
      <c:legendPos val="r"/>
      <c:layout>
        <c:manualLayout>
          <c:xMode val="edge"/>
          <c:yMode val="edge"/>
          <c:x val="0.206237314085739"/>
          <c:y val="6.4430956547098295E-2"/>
          <c:w val="0.15765157480315001"/>
          <c:h val="0.181323272090989"/>
        </c:manualLayout>
      </c:layout>
      <c:overlay val="0"/>
      <c:txPr>
        <a:bodyPr/>
        <a:lstStyle/>
        <a:p>
          <a:pPr>
            <a:defRPr sz="1100">
              <a:latin typeface="Arial" charset="0"/>
              <a:ea typeface="Arial" charset="0"/>
              <a:cs typeface="Arial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730-3640-8CA9-2EBCC1423B06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2730-3640-8CA9-2EBCC1423B0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730-3640-8CA9-2EBCC1423B0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2730-3640-8CA9-2EBCC1423B06}"/>
              </c:ext>
            </c:extLst>
          </c:dPt>
          <c:errBars>
            <c:errBarType val="plus"/>
            <c:errValType val="cust"/>
            <c:noEndCap val="0"/>
            <c:plus>
              <c:numRef>
                <c:f>TregMemory!$G$18:$G$25</c:f>
                <c:numCache>
                  <c:formatCode>General</c:formatCode>
                  <c:ptCount val="8"/>
                  <c:pt idx="0">
                    <c:v>0.44015148907317497</c:v>
                  </c:pt>
                  <c:pt idx="1">
                    <c:v>9.504384952922143E-2</c:v>
                  </c:pt>
                  <c:pt idx="2">
                    <c:v>0.18770544300401437</c:v>
                  </c:pt>
                  <c:pt idx="3">
                    <c:v>0.50846173241782255</c:v>
                  </c:pt>
                  <c:pt idx="4">
                    <c:v>1.0570871928716823</c:v>
                  </c:pt>
                  <c:pt idx="5">
                    <c:v>0.69002415416660068</c:v>
                  </c:pt>
                  <c:pt idx="6">
                    <c:v>3.1850013082153277</c:v>
                  </c:pt>
                  <c:pt idx="7">
                    <c:v>1.31011449881298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TregMemory!$B$28:$B$35</c:f>
              <c:strCache>
                <c:ptCount val="8"/>
                <c:pt idx="0">
                  <c:v>WT</c:v>
                </c:pt>
                <c:pt idx="1">
                  <c:v>Smad4TKO</c:v>
                </c:pt>
                <c:pt idx="2">
                  <c:v>IFNgKO</c:v>
                </c:pt>
                <c:pt idx="3">
                  <c:v>DKO</c:v>
                </c:pt>
                <c:pt idx="4">
                  <c:v>WT</c:v>
                </c:pt>
                <c:pt idx="5">
                  <c:v>Smad4TKO</c:v>
                </c:pt>
                <c:pt idx="6">
                  <c:v>IFNgKO</c:v>
                </c:pt>
                <c:pt idx="7">
                  <c:v>DKO</c:v>
                </c:pt>
              </c:strCache>
            </c:strRef>
          </c:cat>
          <c:val>
            <c:numRef>
              <c:f>TregMemory!$C$28:$C$35</c:f>
              <c:numCache>
                <c:formatCode>General</c:formatCode>
                <c:ptCount val="8"/>
                <c:pt idx="0">
                  <c:v>6.3866666666666676</c:v>
                </c:pt>
                <c:pt idx="1">
                  <c:v>4.7033333333333331</c:v>
                </c:pt>
                <c:pt idx="2">
                  <c:v>7.3833333333333329</c:v>
                </c:pt>
                <c:pt idx="3">
                  <c:v>18.253333333333334</c:v>
                </c:pt>
                <c:pt idx="4">
                  <c:v>53.476666666666667</c:v>
                </c:pt>
                <c:pt idx="5">
                  <c:v>9.4933333333333341</c:v>
                </c:pt>
                <c:pt idx="6">
                  <c:v>57.196666666666665</c:v>
                </c:pt>
                <c:pt idx="7">
                  <c:v>21.62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30-3640-8CA9-2EBCC1423B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654039552"/>
        <c:axId val="1655835984"/>
      </c:barChart>
      <c:catAx>
        <c:axId val="1654039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5835984"/>
        <c:crosses val="autoZero"/>
        <c:auto val="1"/>
        <c:lblAlgn val="ctr"/>
        <c:lblOffset val="100"/>
        <c:noMultiLvlLbl val="0"/>
      </c:catAx>
      <c:valAx>
        <c:axId val="16558359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prstDash val="sysDot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 Foxp3+CD4+ Cel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4039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PD-L1</a:t>
            </a:r>
            <a:endParaRPr lang="en-US">
              <a:solidFill>
                <a:schemeClr val="tx1"/>
              </a:solidFill>
              <a:latin typeface="Symbol" charset="2"/>
              <a:ea typeface="Symbol" charset="2"/>
              <a:cs typeface="Symbol" charset="2"/>
            </a:endParaRPr>
          </a:p>
        </c:rich>
      </c:tx>
      <c:layout>
        <c:manualLayout>
          <c:xMode val="edge"/>
          <c:yMode val="edge"/>
          <c:x val="0.46166561264907013"/>
          <c:y val="9.2592626346101759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302-A54A-B7A7-AE8E96D9E1CC}"/>
              </c:ext>
            </c:extLst>
          </c:dPt>
          <c:errBars>
            <c:errBarType val="plus"/>
            <c:errValType val="cust"/>
            <c:noEndCap val="0"/>
            <c:plus>
              <c:numRef>
                <c:f>'IHC in VEGF MM'!$AA$6:$AD$6</c:f>
                <c:numCache>
                  <c:formatCode>General</c:formatCode>
                  <c:ptCount val="4"/>
                  <c:pt idx="0">
                    <c:v>0.2</c:v>
                  </c:pt>
                  <c:pt idx="1">
                    <c:v>2.7</c:v>
                  </c:pt>
                  <c:pt idx="2">
                    <c:v>0.3</c:v>
                  </c:pt>
                  <c:pt idx="3">
                    <c:v>0.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HC in VEGF MM'!$AA$3:$AD$3</c:f>
              <c:strCache>
                <c:ptCount val="4"/>
                <c:pt idx="0">
                  <c:v>WT</c:v>
                </c:pt>
                <c:pt idx="1">
                  <c:v>Smad4TKO</c:v>
                </c:pt>
                <c:pt idx="2">
                  <c:v>IFN-gKO</c:v>
                </c:pt>
                <c:pt idx="3">
                  <c:v>DKO</c:v>
                </c:pt>
              </c:strCache>
            </c:strRef>
          </c:cat>
          <c:val>
            <c:numRef>
              <c:f>'IHC in VEGF MM'!$AA$4:$AD$4</c:f>
              <c:numCache>
                <c:formatCode>General</c:formatCode>
                <c:ptCount val="4"/>
                <c:pt idx="0">
                  <c:v>1</c:v>
                </c:pt>
                <c:pt idx="1">
                  <c:v>22.1</c:v>
                </c:pt>
                <c:pt idx="2">
                  <c:v>0.7</c:v>
                </c:pt>
                <c:pt idx="3">
                  <c:v>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302-A54A-B7A7-AE8E96D9E1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-1635803856"/>
        <c:axId val="-2074120656"/>
      </c:barChart>
      <c:catAx>
        <c:axId val="-1635803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2074120656"/>
        <c:crosses val="autoZero"/>
        <c:auto val="1"/>
        <c:lblAlgn val="ctr"/>
        <c:lblOffset val="100"/>
        <c:noMultiLvlLbl val="0"/>
      </c:catAx>
      <c:valAx>
        <c:axId val="-2074120656"/>
        <c:scaling>
          <c:orientation val="minMax"/>
          <c:max val="25"/>
          <c:min val="0"/>
        </c:scaling>
        <c:delete val="0"/>
        <c:axPos val="l"/>
        <c:majorGridlines>
          <c:spPr>
            <a:ln w="9525" cap="flat" cmpd="sng" algn="ctr">
              <a:noFill/>
              <a:prstDash val="sysDot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 sz="1200" b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PD-l1</a:t>
                </a:r>
                <a:r>
                  <a:rPr lang="en-US" sz="1200" b="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 IHC Score</a:t>
                </a:r>
                <a:endParaRPr lang="en-US" sz="1200" b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63580385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4C680A-269F-C74B-9874-CF1806AA1FD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0D16C5-CB84-A84B-8A1F-0A82288372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537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0D16C5-CB84-A84B-8A1F-0A822883723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5592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0D16C5-CB84-A84B-8A1F-0A822883723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5633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0D16C5-CB84-A84B-8A1F-0A822883723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6789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0D16C5-CB84-A84B-8A1F-0A822883723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2227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639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69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953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58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99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323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921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640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964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285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802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71A17-A254-2E47-BD7C-D4C82A5D11F6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6542B-6944-4447-ADF1-089D3E5844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647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wmf"/><Relationship Id="rId3" Type="http://schemas.openxmlformats.org/officeDocument/2006/relationships/image" Target="../media/image1.wmf"/><Relationship Id="rId7" Type="http://schemas.openxmlformats.org/officeDocument/2006/relationships/image" Target="../media/image5.w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wmf"/><Relationship Id="rId5" Type="http://schemas.openxmlformats.org/officeDocument/2006/relationships/image" Target="../media/image3.wmf"/><Relationship Id="rId4" Type="http://schemas.openxmlformats.org/officeDocument/2006/relationships/image" Target="../media/image2.w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7.png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3"/>
          <p:cNvSpPr>
            <a:spLocks noChangeArrowheads="1"/>
          </p:cNvSpPr>
          <p:nvPr/>
        </p:nvSpPr>
        <p:spPr bwMode="auto">
          <a:xfrm>
            <a:off x="6751" y="6750"/>
            <a:ext cx="3024316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579438" indent="-579438" algn="ctr" latinLnBrk="0">
              <a:spcBef>
                <a:spcPct val="20000"/>
              </a:spcBef>
            </a:pPr>
            <a:r>
              <a:rPr lang="en-US" altLang="ko-KR" dirty="0">
                <a:solidFill>
                  <a:srgbClr val="003366"/>
                </a:solidFill>
                <a:latin typeface="Arial" charset="0"/>
              </a:rPr>
              <a:t>Supplementary F</a:t>
            </a:r>
            <a:r>
              <a:rPr kumimoji="0" lang="en-US" altLang="ko-KR" sz="1800" dirty="0">
                <a:solidFill>
                  <a:srgbClr val="003366"/>
                </a:solidFill>
                <a:latin typeface="Arial" charset="0"/>
              </a:rPr>
              <a:t>igure </a:t>
            </a:r>
            <a:r>
              <a:rPr lang="en-US" altLang="ko-KR" dirty="0">
                <a:solidFill>
                  <a:srgbClr val="003366"/>
                </a:solidFill>
                <a:latin typeface="Arial" charset="0"/>
              </a:rPr>
              <a:t>1</a:t>
            </a:r>
            <a:endParaRPr kumimoji="0" lang="en-US" altLang="ko-KR" sz="1800" dirty="0">
              <a:solidFill>
                <a:srgbClr val="003366"/>
              </a:solidFill>
              <a:latin typeface="Arial" charset="0"/>
            </a:endParaRPr>
          </a:p>
        </p:txBody>
      </p:sp>
      <p:sp>
        <p:nvSpPr>
          <p:cNvPr id="132" name="Rectangle 3"/>
          <p:cNvSpPr>
            <a:spLocks noChangeArrowheads="1"/>
          </p:cNvSpPr>
          <p:nvPr/>
        </p:nvSpPr>
        <p:spPr bwMode="auto">
          <a:xfrm>
            <a:off x="133297" y="685380"/>
            <a:ext cx="4572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579438" indent="-579438" algn="ctr" latinLnBrk="0">
              <a:spcBef>
                <a:spcPct val="20000"/>
              </a:spcBef>
            </a:pPr>
            <a:r>
              <a:rPr kumimoji="0" lang="en-US" altLang="ko-KR" sz="1800" b="1" dirty="0">
                <a:latin typeface="Arial" charset="0"/>
              </a:rPr>
              <a:t>A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03F6AE7-BA68-E146-9CFB-D59473E63808}"/>
              </a:ext>
            </a:extLst>
          </p:cNvPr>
          <p:cNvGrpSpPr/>
          <p:nvPr/>
        </p:nvGrpSpPr>
        <p:grpSpPr>
          <a:xfrm>
            <a:off x="4281858" y="1096568"/>
            <a:ext cx="1635124" cy="1846468"/>
            <a:chOff x="1045685" y="981581"/>
            <a:chExt cx="1635124" cy="1846468"/>
          </a:xfrm>
        </p:grpSpPr>
        <p:sp>
          <p:nvSpPr>
            <p:cNvPr id="12" name="Text Box 13">
              <a:extLst>
                <a:ext uri="{FF2B5EF4-FFF2-40B4-BE49-F238E27FC236}">
                  <a16:creationId xmlns:a16="http://schemas.microsoft.com/office/drawing/2014/main" id="{7775B03C-B975-2F4E-86C8-F149FBDD76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66384" y="2520272"/>
              <a:ext cx="95250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2400"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>
                  <a:solidFill>
                    <a:srgbClr val="000000"/>
                  </a:solidFill>
                  <a:latin typeface="Arial" charset="0"/>
                  <a:ea typeface="MS PGothic" charset="-128"/>
                </a:defRPr>
              </a:lvl9pPr>
            </a:lstStyle>
            <a:p>
              <a:pPr eaLnBrk="1" fontAlgn="auto" hangingPunct="1">
                <a:spcBef>
                  <a:spcPct val="0"/>
                </a:spcBef>
                <a:spcAft>
                  <a:spcPts val="0"/>
                </a:spcAft>
                <a:buFontTx/>
                <a:buNone/>
                <a:defRPr/>
              </a:pPr>
              <a:r>
                <a:rPr kumimoji="1" lang="en-US" altLang="ko-KR" sz="1400" kern="0" dirty="0">
                  <a:solidFill>
                    <a:schemeClr val="tx1"/>
                  </a:solidFill>
                  <a:cs typeface="+mn-cs"/>
                </a:rPr>
                <a:t>Cell cycle</a:t>
              </a:r>
            </a:p>
          </p:txBody>
        </p:sp>
        <p:grpSp>
          <p:nvGrpSpPr>
            <p:cNvPr id="13" name="Group 6">
              <a:extLst>
                <a:ext uri="{FF2B5EF4-FFF2-40B4-BE49-F238E27FC236}">
                  <a16:creationId xmlns:a16="http://schemas.microsoft.com/office/drawing/2014/main" id="{58344997-F216-5F44-AFC4-E6FD290819B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045685" y="981581"/>
              <a:ext cx="1635124" cy="1525588"/>
              <a:chOff x="6800537" y="4629901"/>
              <a:chExt cx="1635193" cy="1524556"/>
            </a:xfrm>
          </p:grpSpPr>
          <p:grpSp>
            <p:nvGrpSpPr>
              <p:cNvPr id="14" name="Group 19">
                <a:extLst>
                  <a:ext uri="{FF2B5EF4-FFF2-40B4-BE49-F238E27FC236}">
                    <a16:creationId xmlns:a16="http://schemas.microsoft.com/office/drawing/2014/main" id="{0EC51338-2999-CB4C-B300-18070AADF41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976355" y="4629901"/>
                <a:ext cx="1459375" cy="1256050"/>
                <a:chOff x="6887234" y="4638592"/>
                <a:chExt cx="1459375" cy="1256050"/>
              </a:xfrm>
            </p:grpSpPr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F12D9EEA-3473-1943-810E-AC2D9598364A}"/>
                    </a:ext>
                  </a:extLst>
                </p:cNvPr>
                <p:cNvSpPr/>
                <p:nvPr/>
              </p:nvSpPr>
              <p:spPr>
                <a:xfrm>
                  <a:off x="7514724" y="4801994"/>
                  <a:ext cx="701705" cy="331563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F25B043E-A82E-9041-9401-E849C104601A}"/>
                    </a:ext>
                  </a:extLst>
                </p:cNvPr>
                <p:cNvSpPr/>
                <p:nvPr/>
              </p:nvSpPr>
              <p:spPr>
                <a:xfrm>
                  <a:off x="7443284" y="5390558"/>
                  <a:ext cx="269886" cy="331564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5295D3C1-C191-1240-A13D-3E61D0552DA3}"/>
                    </a:ext>
                  </a:extLst>
                </p:cNvPr>
                <p:cNvSpPr/>
                <p:nvPr/>
              </p:nvSpPr>
              <p:spPr>
                <a:xfrm>
                  <a:off x="7829062" y="5214465"/>
                  <a:ext cx="395305" cy="329977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  <p:sp>
              <p:nvSpPr>
                <p:cNvPr id="23" name="Freeform 22">
                  <a:extLst>
                    <a:ext uri="{FF2B5EF4-FFF2-40B4-BE49-F238E27FC236}">
                      <a16:creationId xmlns:a16="http://schemas.microsoft.com/office/drawing/2014/main" id="{A0CE2645-90AC-0D44-A58A-5F063E325763}"/>
                    </a:ext>
                  </a:extLst>
                </p:cNvPr>
                <p:cNvSpPr/>
                <p:nvPr/>
              </p:nvSpPr>
              <p:spPr>
                <a:xfrm>
                  <a:off x="7114657" y="5133557"/>
                  <a:ext cx="400067" cy="493379"/>
                </a:xfrm>
                <a:custGeom>
                  <a:avLst/>
                  <a:gdLst>
                    <a:gd name="connsiteX0" fmla="*/ 850392 w 1078992"/>
                    <a:gd name="connsiteY0" fmla="*/ 27432 h 1129250"/>
                    <a:gd name="connsiteX1" fmla="*/ 850392 w 1078992"/>
                    <a:gd name="connsiteY1" fmla="*/ 27432 h 1129250"/>
                    <a:gd name="connsiteX2" fmla="*/ 777240 w 1078992"/>
                    <a:gd name="connsiteY2" fmla="*/ 64008 h 1129250"/>
                    <a:gd name="connsiteX3" fmla="*/ 749808 w 1078992"/>
                    <a:gd name="connsiteY3" fmla="*/ 82296 h 1129250"/>
                    <a:gd name="connsiteX4" fmla="*/ 704088 w 1078992"/>
                    <a:gd name="connsiteY4" fmla="*/ 100584 h 1129250"/>
                    <a:gd name="connsiteX5" fmla="*/ 658368 w 1078992"/>
                    <a:gd name="connsiteY5" fmla="*/ 128016 h 1129250"/>
                    <a:gd name="connsiteX6" fmla="*/ 566928 w 1078992"/>
                    <a:gd name="connsiteY6" fmla="*/ 173736 h 1129250"/>
                    <a:gd name="connsiteX7" fmla="*/ 530352 w 1078992"/>
                    <a:gd name="connsiteY7" fmla="*/ 210312 h 1129250"/>
                    <a:gd name="connsiteX8" fmla="*/ 466344 w 1078992"/>
                    <a:gd name="connsiteY8" fmla="*/ 246888 h 1129250"/>
                    <a:gd name="connsiteX9" fmla="*/ 438912 w 1078992"/>
                    <a:gd name="connsiteY9" fmla="*/ 274320 h 1129250"/>
                    <a:gd name="connsiteX10" fmla="*/ 365760 w 1078992"/>
                    <a:gd name="connsiteY10" fmla="*/ 310896 h 1129250"/>
                    <a:gd name="connsiteX11" fmla="*/ 338328 w 1078992"/>
                    <a:gd name="connsiteY11" fmla="*/ 320040 h 1129250"/>
                    <a:gd name="connsiteX12" fmla="*/ 283464 w 1078992"/>
                    <a:gd name="connsiteY12" fmla="*/ 356616 h 1129250"/>
                    <a:gd name="connsiteX13" fmla="*/ 256032 w 1078992"/>
                    <a:gd name="connsiteY13" fmla="*/ 365760 h 1129250"/>
                    <a:gd name="connsiteX14" fmla="*/ 201168 w 1078992"/>
                    <a:gd name="connsiteY14" fmla="*/ 402336 h 1129250"/>
                    <a:gd name="connsiteX15" fmla="*/ 173736 w 1078992"/>
                    <a:gd name="connsiteY15" fmla="*/ 420624 h 1129250"/>
                    <a:gd name="connsiteX16" fmla="*/ 155448 w 1078992"/>
                    <a:gd name="connsiteY16" fmla="*/ 448056 h 1129250"/>
                    <a:gd name="connsiteX17" fmla="*/ 128016 w 1078992"/>
                    <a:gd name="connsiteY17" fmla="*/ 475488 h 1129250"/>
                    <a:gd name="connsiteX18" fmla="*/ 91440 w 1078992"/>
                    <a:gd name="connsiteY18" fmla="*/ 530352 h 1129250"/>
                    <a:gd name="connsiteX19" fmla="*/ 82296 w 1078992"/>
                    <a:gd name="connsiteY19" fmla="*/ 576072 h 1129250"/>
                    <a:gd name="connsiteX20" fmla="*/ 73152 w 1078992"/>
                    <a:gd name="connsiteY20" fmla="*/ 658368 h 1129250"/>
                    <a:gd name="connsiteX21" fmla="*/ 64008 w 1078992"/>
                    <a:gd name="connsiteY21" fmla="*/ 731520 h 1129250"/>
                    <a:gd name="connsiteX22" fmla="*/ 54864 w 1078992"/>
                    <a:gd name="connsiteY22" fmla="*/ 832104 h 1129250"/>
                    <a:gd name="connsiteX23" fmla="*/ 36576 w 1078992"/>
                    <a:gd name="connsiteY23" fmla="*/ 941832 h 1129250"/>
                    <a:gd name="connsiteX24" fmla="*/ 27432 w 1078992"/>
                    <a:gd name="connsiteY24" fmla="*/ 1005840 h 1129250"/>
                    <a:gd name="connsiteX25" fmla="*/ 9144 w 1078992"/>
                    <a:gd name="connsiteY25" fmla="*/ 1060704 h 1129250"/>
                    <a:gd name="connsiteX26" fmla="*/ 0 w 1078992"/>
                    <a:gd name="connsiteY26" fmla="*/ 1097280 h 1129250"/>
                    <a:gd name="connsiteX27" fmla="*/ 9144 w 1078992"/>
                    <a:gd name="connsiteY27" fmla="*/ 1124712 h 1129250"/>
                    <a:gd name="connsiteX28" fmla="*/ 228600 w 1078992"/>
                    <a:gd name="connsiteY28" fmla="*/ 1106424 h 1129250"/>
                    <a:gd name="connsiteX29" fmla="*/ 246888 w 1078992"/>
                    <a:gd name="connsiteY29" fmla="*/ 1078992 h 1129250"/>
                    <a:gd name="connsiteX30" fmla="*/ 265176 w 1078992"/>
                    <a:gd name="connsiteY30" fmla="*/ 1024128 h 1129250"/>
                    <a:gd name="connsiteX31" fmla="*/ 283464 w 1078992"/>
                    <a:gd name="connsiteY31" fmla="*/ 996696 h 1129250"/>
                    <a:gd name="connsiteX32" fmla="*/ 329184 w 1078992"/>
                    <a:gd name="connsiteY32" fmla="*/ 914400 h 1129250"/>
                    <a:gd name="connsiteX33" fmla="*/ 347472 w 1078992"/>
                    <a:gd name="connsiteY33" fmla="*/ 859536 h 1129250"/>
                    <a:gd name="connsiteX34" fmla="*/ 356616 w 1078992"/>
                    <a:gd name="connsiteY34" fmla="*/ 832104 h 1129250"/>
                    <a:gd name="connsiteX35" fmla="*/ 374904 w 1078992"/>
                    <a:gd name="connsiteY35" fmla="*/ 804672 h 1129250"/>
                    <a:gd name="connsiteX36" fmla="*/ 393192 w 1078992"/>
                    <a:gd name="connsiteY36" fmla="*/ 749808 h 1129250"/>
                    <a:gd name="connsiteX37" fmla="*/ 457200 w 1078992"/>
                    <a:gd name="connsiteY37" fmla="*/ 676656 h 1129250"/>
                    <a:gd name="connsiteX38" fmla="*/ 493776 w 1078992"/>
                    <a:gd name="connsiteY38" fmla="*/ 640080 h 1129250"/>
                    <a:gd name="connsiteX39" fmla="*/ 502920 w 1078992"/>
                    <a:gd name="connsiteY39" fmla="*/ 612648 h 1129250"/>
                    <a:gd name="connsiteX40" fmla="*/ 585216 w 1078992"/>
                    <a:gd name="connsiteY40" fmla="*/ 566928 h 1129250"/>
                    <a:gd name="connsiteX41" fmla="*/ 640080 w 1078992"/>
                    <a:gd name="connsiteY41" fmla="*/ 539496 h 1129250"/>
                    <a:gd name="connsiteX42" fmla="*/ 731520 w 1078992"/>
                    <a:gd name="connsiteY42" fmla="*/ 475488 h 1129250"/>
                    <a:gd name="connsiteX43" fmla="*/ 758952 w 1078992"/>
                    <a:gd name="connsiteY43" fmla="*/ 457200 h 1129250"/>
                    <a:gd name="connsiteX44" fmla="*/ 822960 w 1078992"/>
                    <a:gd name="connsiteY44" fmla="*/ 411480 h 1129250"/>
                    <a:gd name="connsiteX45" fmla="*/ 868680 w 1078992"/>
                    <a:gd name="connsiteY45" fmla="*/ 365760 h 1129250"/>
                    <a:gd name="connsiteX46" fmla="*/ 896112 w 1078992"/>
                    <a:gd name="connsiteY46" fmla="*/ 338328 h 1129250"/>
                    <a:gd name="connsiteX47" fmla="*/ 914400 w 1078992"/>
                    <a:gd name="connsiteY47" fmla="*/ 310896 h 1129250"/>
                    <a:gd name="connsiteX48" fmla="*/ 978408 w 1078992"/>
                    <a:gd name="connsiteY48" fmla="*/ 283464 h 1129250"/>
                    <a:gd name="connsiteX49" fmla="*/ 987552 w 1078992"/>
                    <a:gd name="connsiteY49" fmla="*/ 256032 h 1129250"/>
                    <a:gd name="connsiteX50" fmla="*/ 1014984 w 1078992"/>
                    <a:gd name="connsiteY50" fmla="*/ 228600 h 1129250"/>
                    <a:gd name="connsiteX51" fmla="*/ 1042416 w 1078992"/>
                    <a:gd name="connsiteY51" fmla="*/ 192024 h 1129250"/>
                    <a:gd name="connsiteX52" fmla="*/ 1078992 w 1078992"/>
                    <a:gd name="connsiteY52" fmla="*/ 137160 h 1129250"/>
                    <a:gd name="connsiteX53" fmla="*/ 1060704 w 1078992"/>
                    <a:gd name="connsiteY53" fmla="*/ 100584 h 1129250"/>
                    <a:gd name="connsiteX54" fmla="*/ 1005840 w 1078992"/>
                    <a:gd name="connsiteY54" fmla="*/ 64008 h 1129250"/>
                    <a:gd name="connsiteX55" fmla="*/ 950976 w 1078992"/>
                    <a:gd name="connsiteY55" fmla="*/ 27432 h 1129250"/>
                    <a:gd name="connsiteX56" fmla="*/ 877824 w 1078992"/>
                    <a:gd name="connsiteY56" fmla="*/ 0 h 1129250"/>
                    <a:gd name="connsiteX57" fmla="*/ 822960 w 1078992"/>
                    <a:gd name="connsiteY57" fmla="*/ 9144 h 1129250"/>
                    <a:gd name="connsiteX58" fmla="*/ 795528 w 1078992"/>
                    <a:gd name="connsiteY58" fmla="*/ 27432 h 1129250"/>
                    <a:gd name="connsiteX59" fmla="*/ 795528 w 1078992"/>
                    <a:gd name="connsiteY59" fmla="*/ 27432 h 1129250"/>
                    <a:gd name="connsiteX60" fmla="*/ 850392 w 1078992"/>
                    <a:gd name="connsiteY60" fmla="*/ 27432 h 11292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</a:cxnLst>
                  <a:rect l="l" t="t" r="r" b="b"/>
                  <a:pathLst>
                    <a:path w="1078992" h="1129250">
                      <a:moveTo>
                        <a:pt x="850392" y="27432"/>
                      </a:moveTo>
                      <a:lnTo>
                        <a:pt x="850392" y="27432"/>
                      </a:lnTo>
                      <a:cubicBezTo>
                        <a:pt x="826008" y="39624"/>
                        <a:pt x="801173" y="50953"/>
                        <a:pt x="777240" y="64008"/>
                      </a:cubicBezTo>
                      <a:cubicBezTo>
                        <a:pt x="767592" y="69270"/>
                        <a:pt x="759638" y="77381"/>
                        <a:pt x="749808" y="82296"/>
                      </a:cubicBezTo>
                      <a:cubicBezTo>
                        <a:pt x="735127" y="89637"/>
                        <a:pt x="718769" y="93243"/>
                        <a:pt x="704088" y="100584"/>
                      </a:cubicBezTo>
                      <a:cubicBezTo>
                        <a:pt x="688192" y="108532"/>
                        <a:pt x="674050" y="119652"/>
                        <a:pt x="658368" y="128016"/>
                      </a:cubicBezTo>
                      <a:cubicBezTo>
                        <a:pt x="628299" y="144053"/>
                        <a:pt x="591025" y="149639"/>
                        <a:pt x="566928" y="173736"/>
                      </a:cubicBezTo>
                      <a:cubicBezTo>
                        <a:pt x="554736" y="185928"/>
                        <a:pt x="544146" y="199967"/>
                        <a:pt x="530352" y="210312"/>
                      </a:cubicBezTo>
                      <a:cubicBezTo>
                        <a:pt x="440916" y="277389"/>
                        <a:pt x="539810" y="185666"/>
                        <a:pt x="466344" y="246888"/>
                      </a:cubicBezTo>
                      <a:cubicBezTo>
                        <a:pt x="456410" y="255167"/>
                        <a:pt x="449822" y="267377"/>
                        <a:pt x="438912" y="274320"/>
                      </a:cubicBezTo>
                      <a:cubicBezTo>
                        <a:pt x="415912" y="288956"/>
                        <a:pt x="391623" y="302275"/>
                        <a:pt x="365760" y="310896"/>
                      </a:cubicBezTo>
                      <a:cubicBezTo>
                        <a:pt x="356616" y="313944"/>
                        <a:pt x="346754" y="315359"/>
                        <a:pt x="338328" y="320040"/>
                      </a:cubicBezTo>
                      <a:cubicBezTo>
                        <a:pt x="319115" y="330714"/>
                        <a:pt x="304316" y="349665"/>
                        <a:pt x="283464" y="356616"/>
                      </a:cubicBezTo>
                      <a:cubicBezTo>
                        <a:pt x="274320" y="359664"/>
                        <a:pt x="264458" y="361079"/>
                        <a:pt x="256032" y="365760"/>
                      </a:cubicBezTo>
                      <a:cubicBezTo>
                        <a:pt x="236819" y="376434"/>
                        <a:pt x="219456" y="390144"/>
                        <a:pt x="201168" y="402336"/>
                      </a:cubicBezTo>
                      <a:lnTo>
                        <a:pt x="173736" y="420624"/>
                      </a:lnTo>
                      <a:cubicBezTo>
                        <a:pt x="167640" y="429768"/>
                        <a:pt x="162483" y="439613"/>
                        <a:pt x="155448" y="448056"/>
                      </a:cubicBezTo>
                      <a:cubicBezTo>
                        <a:pt x="147169" y="457990"/>
                        <a:pt x="135189" y="464728"/>
                        <a:pt x="128016" y="475488"/>
                      </a:cubicBezTo>
                      <a:cubicBezTo>
                        <a:pt x="75083" y="554888"/>
                        <a:pt x="178951" y="442841"/>
                        <a:pt x="91440" y="530352"/>
                      </a:cubicBezTo>
                      <a:cubicBezTo>
                        <a:pt x="88392" y="545592"/>
                        <a:pt x="84494" y="560686"/>
                        <a:pt x="82296" y="576072"/>
                      </a:cubicBezTo>
                      <a:cubicBezTo>
                        <a:pt x="78393" y="603395"/>
                        <a:pt x="76377" y="630956"/>
                        <a:pt x="73152" y="658368"/>
                      </a:cubicBezTo>
                      <a:cubicBezTo>
                        <a:pt x="70281" y="682773"/>
                        <a:pt x="66580" y="707081"/>
                        <a:pt x="64008" y="731520"/>
                      </a:cubicBezTo>
                      <a:cubicBezTo>
                        <a:pt x="60484" y="765001"/>
                        <a:pt x="58582" y="798644"/>
                        <a:pt x="54864" y="832104"/>
                      </a:cubicBezTo>
                      <a:cubicBezTo>
                        <a:pt x="44903" y="921756"/>
                        <a:pt x="48951" y="867581"/>
                        <a:pt x="36576" y="941832"/>
                      </a:cubicBezTo>
                      <a:cubicBezTo>
                        <a:pt x="33033" y="963091"/>
                        <a:pt x="32278" y="984839"/>
                        <a:pt x="27432" y="1005840"/>
                      </a:cubicBezTo>
                      <a:cubicBezTo>
                        <a:pt x="23097" y="1024624"/>
                        <a:pt x="13819" y="1042002"/>
                        <a:pt x="9144" y="1060704"/>
                      </a:cubicBezTo>
                      <a:lnTo>
                        <a:pt x="0" y="1097280"/>
                      </a:lnTo>
                      <a:cubicBezTo>
                        <a:pt x="3048" y="1106424"/>
                        <a:pt x="-451" y="1123798"/>
                        <a:pt x="9144" y="1124712"/>
                      </a:cubicBezTo>
                      <a:cubicBezTo>
                        <a:pt x="122360" y="1135494"/>
                        <a:pt x="149738" y="1126139"/>
                        <a:pt x="228600" y="1106424"/>
                      </a:cubicBezTo>
                      <a:cubicBezTo>
                        <a:pt x="234696" y="1097280"/>
                        <a:pt x="242425" y="1089035"/>
                        <a:pt x="246888" y="1078992"/>
                      </a:cubicBezTo>
                      <a:cubicBezTo>
                        <a:pt x="254717" y="1061376"/>
                        <a:pt x="254483" y="1040168"/>
                        <a:pt x="265176" y="1024128"/>
                      </a:cubicBezTo>
                      <a:cubicBezTo>
                        <a:pt x="271272" y="1014984"/>
                        <a:pt x="279001" y="1006739"/>
                        <a:pt x="283464" y="996696"/>
                      </a:cubicBezTo>
                      <a:cubicBezTo>
                        <a:pt x="319268" y="916138"/>
                        <a:pt x="279114" y="964470"/>
                        <a:pt x="329184" y="914400"/>
                      </a:cubicBezTo>
                      <a:lnTo>
                        <a:pt x="347472" y="859536"/>
                      </a:lnTo>
                      <a:cubicBezTo>
                        <a:pt x="350520" y="850392"/>
                        <a:pt x="351269" y="840124"/>
                        <a:pt x="356616" y="832104"/>
                      </a:cubicBezTo>
                      <a:cubicBezTo>
                        <a:pt x="362712" y="822960"/>
                        <a:pt x="370441" y="814715"/>
                        <a:pt x="374904" y="804672"/>
                      </a:cubicBezTo>
                      <a:cubicBezTo>
                        <a:pt x="382733" y="787056"/>
                        <a:pt x="382499" y="765848"/>
                        <a:pt x="393192" y="749808"/>
                      </a:cubicBezTo>
                      <a:cubicBezTo>
                        <a:pt x="435864" y="685800"/>
                        <a:pt x="411480" y="707136"/>
                        <a:pt x="457200" y="676656"/>
                      </a:cubicBezTo>
                      <a:cubicBezTo>
                        <a:pt x="481584" y="603504"/>
                        <a:pt x="445008" y="688848"/>
                        <a:pt x="493776" y="640080"/>
                      </a:cubicBezTo>
                      <a:cubicBezTo>
                        <a:pt x="500592" y="633264"/>
                        <a:pt x="496104" y="619464"/>
                        <a:pt x="502920" y="612648"/>
                      </a:cubicBezTo>
                      <a:cubicBezTo>
                        <a:pt x="560582" y="554986"/>
                        <a:pt x="539222" y="589925"/>
                        <a:pt x="585216" y="566928"/>
                      </a:cubicBezTo>
                      <a:cubicBezTo>
                        <a:pt x="656120" y="531476"/>
                        <a:pt x="571129" y="562480"/>
                        <a:pt x="640080" y="539496"/>
                      </a:cubicBezTo>
                      <a:cubicBezTo>
                        <a:pt x="694240" y="498876"/>
                        <a:pt x="663976" y="520518"/>
                        <a:pt x="731520" y="475488"/>
                      </a:cubicBezTo>
                      <a:cubicBezTo>
                        <a:pt x="740664" y="469392"/>
                        <a:pt x="751181" y="464971"/>
                        <a:pt x="758952" y="457200"/>
                      </a:cubicBezTo>
                      <a:cubicBezTo>
                        <a:pt x="796023" y="420129"/>
                        <a:pt x="774818" y="435551"/>
                        <a:pt x="822960" y="411480"/>
                      </a:cubicBezTo>
                      <a:cubicBezTo>
                        <a:pt x="856488" y="361188"/>
                        <a:pt x="822960" y="403860"/>
                        <a:pt x="868680" y="365760"/>
                      </a:cubicBezTo>
                      <a:cubicBezTo>
                        <a:pt x="878614" y="357481"/>
                        <a:pt x="887833" y="348262"/>
                        <a:pt x="896112" y="338328"/>
                      </a:cubicBezTo>
                      <a:cubicBezTo>
                        <a:pt x="903147" y="329885"/>
                        <a:pt x="905957" y="317931"/>
                        <a:pt x="914400" y="310896"/>
                      </a:cubicBezTo>
                      <a:cubicBezTo>
                        <a:pt x="929466" y="298341"/>
                        <a:pt x="959351" y="289816"/>
                        <a:pt x="978408" y="283464"/>
                      </a:cubicBezTo>
                      <a:cubicBezTo>
                        <a:pt x="981456" y="274320"/>
                        <a:pt x="982205" y="264052"/>
                        <a:pt x="987552" y="256032"/>
                      </a:cubicBezTo>
                      <a:cubicBezTo>
                        <a:pt x="994725" y="245272"/>
                        <a:pt x="1006568" y="238418"/>
                        <a:pt x="1014984" y="228600"/>
                      </a:cubicBezTo>
                      <a:cubicBezTo>
                        <a:pt x="1024902" y="217029"/>
                        <a:pt x="1033676" y="204509"/>
                        <a:pt x="1042416" y="192024"/>
                      </a:cubicBezTo>
                      <a:cubicBezTo>
                        <a:pt x="1055020" y="174018"/>
                        <a:pt x="1078992" y="137160"/>
                        <a:pt x="1078992" y="137160"/>
                      </a:cubicBezTo>
                      <a:cubicBezTo>
                        <a:pt x="1072896" y="124968"/>
                        <a:pt x="1070343" y="110223"/>
                        <a:pt x="1060704" y="100584"/>
                      </a:cubicBezTo>
                      <a:cubicBezTo>
                        <a:pt x="1045162" y="85042"/>
                        <a:pt x="1005840" y="64008"/>
                        <a:pt x="1005840" y="64008"/>
                      </a:cubicBezTo>
                      <a:cubicBezTo>
                        <a:pt x="973696" y="15792"/>
                        <a:pt x="1006087" y="51051"/>
                        <a:pt x="950976" y="27432"/>
                      </a:cubicBezTo>
                      <a:cubicBezTo>
                        <a:pt x="868567" y="-7886"/>
                        <a:pt x="993781" y="23191"/>
                        <a:pt x="877824" y="0"/>
                      </a:cubicBezTo>
                      <a:cubicBezTo>
                        <a:pt x="859536" y="3048"/>
                        <a:pt x="840549" y="3281"/>
                        <a:pt x="822960" y="9144"/>
                      </a:cubicBezTo>
                      <a:cubicBezTo>
                        <a:pt x="812534" y="12619"/>
                        <a:pt x="795528" y="27432"/>
                        <a:pt x="795528" y="27432"/>
                      </a:cubicBezTo>
                      <a:lnTo>
                        <a:pt x="795528" y="27432"/>
                      </a:lnTo>
                      <a:lnTo>
                        <a:pt x="850392" y="27432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  <p:sp>
              <p:nvSpPr>
                <p:cNvPr id="24" name="Rectangle 21">
                  <a:extLst>
                    <a:ext uri="{FF2B5EF4-FFF2-40B4-BE49-F238E27FC236}">
                      <a16:creationId xmlns:a16="http://schemas.microsoft.com/office/drawing/2014/main" id="{77BFF272-3FFE-8744-8BF8-0B3AA12CF03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87635" y="5152594"/>
                  <a:ext cx="696942" cy="268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anchor="ctr"/>
                <a:lstStyle>
                  <a:lvl1pPr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1pPr>
                  <a:lvl2pPr marL="742950" indent="-28575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2pPr>
                  <a:lvl3pPr marL="11430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3pPr>
                  <a:lvl4pPr marL="16002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4pPr>
                  <a:lvl5pPr marL="20574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9pPr>
                </a:lstStyle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ko-KR" sz="1100" b="1" kern="0">
                      <a:solidFill>
                        <a:srgbClr val="002060"/>
                      </a:solidFill>
                      <a:ea typeface="맑은 고딕" charset="-127"/>
                      <a:cs typeface="Arial" charset="0"/>
                    </a:rPr>
                    <a:t>Sub G1</a:t>
                  </a:r>
                  <a:endParaRPr lang="en-US" altLang="ko-KR" sz="1100" b="1" kern="0" dirty="0">
                    <a:solidFill>
                      <a:srgbClr val="002060"/>
                    </a:solidFill>
                    <a:ea typeface="맑은 고딕" charset="-127"/>
                    <a:cs typeface="Arial" charset="0"/>
                  </a:endParaRPr>
                </a:p>
              </p:txBody>
            </p:sp>
            <p:sp>
              <p:nvSpPr>
                <p:cNvPr id="25" name="Rectangle 21">
                  <a:extLst>
                    <a:ext uri="{FF2B5EF4-FFF2-40B4-BE49-F238E27FC236}">
                      <a16:creationId xmlns:a16="http://schemas.microsoft.com/office/drawing/2014/main" id="{9B399F64-3F53-E64A-9DCB-4AF5243D55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86114" y="5409595"/>
                  <a:ext cx="631852" cy="268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anchor="ctr"/>
                <a:lstStyle>
                  <a:lvl1pPr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1pPr>
                  <a:lvl2pPr marL="742950" indent="-28575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2pPr>
                  <a:lvl3pPr marL="11430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3pPr>
                  <a:lvl4pPr marL="16002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4pPr>
                  <a:lvl5pPr marL="20574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9pPr>
                </a:lstStyle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ko-KR" sz="1100" b="1" kern="0">
                      <a:solidFill>
                        <a:srgbClr val="002060"/>
                      </a:solidFill>
                      <a:ea typeface="맑은 고딕" charset="-127"/>
                      <a:cs typeface="Arial" charset="0"/>
                    </a:rPr>
                    <a:t>G0/</a:t>
                  </a:r>
                  <a:r>
                    <a:rPr lang="en-US" altLang="ko-KR" sz="1100" b="1" kern="0" dirty="0">
                      <a:solidFill>
                        <a:srgbClr val="002060"/>
                      </a:solidFill>
                      <a:ea typeface="맑은 고딕" charset="-127"/>
                      <a:cs typeface="Arial" charset="0"/>
                    </a:rPr>
                    <a:t>G1</a:t>
                  </a:r>
                </a:p>
              </p:txBody>
            </p:sp>
            <p:sp>
              <p:nvSpPr>
                <p:cNvPr id="26" name="Rectangle 21">
                  <a:extLst>
                    <a:ext uri="{FF2B5EF4-FFF2-40B4-BE49-F238E27FC236}">
                      <a16:creationId xmlns:a16="http://schemas.microsoft.com/office/drawing/2014/main" id="{47DBC1BC-AB3F-9C49-BCD4-FDA9FC2075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3170" y="5241434"/>
                  <a:ext cx="633439" cy="268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anchor="ctr"/>
                <a:lstStyle>
                  <a:lvl1pPr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1pPr>
                  <a:lvl2pPr marL="742950" indent="-28575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2pPr>
                  <a:lvl3pPr marL="11430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3pPr>
                  <a:lvl4pPr marL="16002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4pPr>
                  <a:lvl5pPr marL="20574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9pPr>
                </a:lstStyle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ko-KR" sz="1100" b="1" kern="0" dirty="0">
                      <a:solidFill>
                        <a:srgbClr val="002060"/>
                      </a:solidFill>
                      <a:ea typeface="맑은 고딕" charset="-127"/>
                      <a:cs typeface="Arial" charset="0"/>
                    </a:rPr>
                    <a:t>G2/M</a:t>
                  </a:r>
                </a:p>
              </p:txBody>
            </p:sp>
            <p:sp>
              <p:nvSpPr>
                <p:cNvPr id="27" name="Rectangle 21">
                  <a:extLst>
                    <a:ext uri="{FF2B5EF4-FFF2-40B4-BE49-F238E27FC236}">
                      <a16:creationId xmlns:a16="http://schemas.microsoft.com/office/drawing/2014/main" id="{F7678472-B903-674F-B1C5-701D1AC82C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00470" y="4849587"/>
                  <a:ext cx="358790" cy="2681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anchor="ctr"/>
                <a:lstStyle>
                  <a:lvl1pPr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1pPr>
                  <a:lvl2pPr marL="742950" indent="-28575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2pPr>
                  <a:lvl3pPr marL="11430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3pPr>
                  <a:lvl4pPr marL="16002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4pPr>
                  <a:lvl5pPr marL="2057400" indent="-228600" defTabSz="457200"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MS PGothic" charset="-128"/>
                    </a:defRPr>
                  </a:lvl9pPr>
                </a:lstStyle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ko-KR" sz="1100" b="1" kern="0" dirty="0">
                      <a:solidFill>
                        <a:srgbClr val="002060"/>
                      </a:solidFill>
                      <a:ea typeface="맑은 고딕" charset="-127"/>
                      <a:cs typeface="Arial" charset="0"/>
                    </a:rPr>
                    <a:t>S</a:t>
                  </a:r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D0027DB7-0A96-A14B-A179-6A82D355B384}"/>
                    </a:ext>
                  </a:extLst>
                </p:cNvPr>
                <p:cNvSpPr/>
                <p:nvPr/>
              </p:nvSpPr>
              <p:spPr>
                <a:xfrm>
                  <a:off x="6959075" y="4638592"/>
                  <a:ext cx="1368483" cy="125645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</p:grpSp>
          <p:sp>
            <p:nvSpPr>
              <p:cNvPr id="15" name="Rectangle 21">
                <a:extLst>
                  <a:ext uri="{FF2B5EF4-FFF2-40B4-BE49-F238E27FC236}">
                    <a16:creationId xmlns:a16="http://schemas.microsoft.com/office/drawing/2014/main" id="{AFFD30C8-045A-BD45-9E4C-E81BF1AA62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00569" y="5965672"/>
                <a:ext cx="817598" cy="1887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anchor="ctr"/>
              <a:lstStyle>
                <a:lvl1pPr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1pPr>
                <a:lvl2pPr marL="742950" indent="-285750"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2pPr>
                <a:lvl3pPr marL="1143000" indent="-228600"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3pPr>
                <a:lvl4pPr marL="1600200" indent="-228600"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4pPr>
                <a:lvl5pPr marL="2057400" indent="-228600"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ko-KR" sz="1200" kern="0" dirty="0">
                    <a:ea typeface="맑은 고딕" charset="-127"/>
                    <a:cs typeface="Arial" charset="0"/>
                  </a:rPr>
                  <a:t>7AAD</a:t>
                </a:r>
              </a:p>
            </p:txBody>
          </p:sp>
          <p:sp>
            <p:nvSpPr>
              <p:cNvPr id="16" name="Line 22">
                <a:extLst>
                  <a:ext uri="{FF2B5EF4-FFF2-40B4-BE49-F238E27FC236}">
                    <a16:creationId xmlns:a16="http://schemas.microsoft.com/office/drawing/2014/main" id="{7E0544ED-A9D0-FB40-ABC8-9231BF79B4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990306" y="5952980"/>
                <a:ext cx="725519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kern="0">
                  <a:solidFill>
                    <a:prstClr val="black"/>
                  </a:solidFill>
                  <a:cs typeface="+mn-cs"/>
                </a:endParaRPr>
              </a:p>
            </p:txBody>
          </p:sp>
          <p:sp>
            <p:nvSpPr>
              <p:cNvPr id="17" name="Rectangle 24">
                <a:extLst>
                  <a:ext uri="{FF2B5EF4-FFF2-40B4-BE49-F238E27FC236}">
                    <a16:creationId xmlns:a16="http://schemas.microsoft.com/office/drawing/2014/main" id="{BF49F2EA-EF63-0044-9CED-E9F8A78302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312">
                <a:off x="6548356" y="5494442"/>
                <a:ext cx="674232" cy="16987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anchor="ctr"/>
              <a:lstStyle>
                <a:lvl1pPr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1pPr>
                <a:lvl2pPr marL="742950" indent="-285750"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2pPr>
                <a:lvl3pPr marL="1143000" indent="-228600"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3pPr>
                <a:lvl4pPr marL="1600200" indent="-228600"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4pPr>
                <a:lvl5pPr marL="2057400" indent="-228600" defTabSz="457200"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MS PGothic" charset="-128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ko-KR" sz="1200" kern="0" dirty="0" err="1">
                    <a:ea typeface="맑은 고딕" charset="-127"/>
                    <a:cs typeface="Arial" charset="0"/>
                  </a:rPr>
                  <a:t>BrdU</a:t>
                </a:r>
                <a:endParaRPr lang="en-US" altLang="ko-KR" sz="1200" kern="0" dirty="0">
                  <a:latin typeface="Symbol" charset="2"/>
                  <a:ea typeface="맑은 고딕" charset="-127"/>
                  <a:cs typeface="Arial" charset="0"/>
                </a:endParaRPr>
              </a:p>
            </p:txBody>
          </p:sp>
          <p:sp>
            <p:nvSpPr>
              <p:cNvPr id="19" name="Line 37">
                <a:extLst>
                  <a:ext uri="{FF2B5EF4-FFF2-40B4-BE49-F238E27FC236}">
                    <a16:creationId xmlns:a16="http://schemas.microsoft.com/office/drawing/2014/main" id="{6920DD93-2AA7-224A-A668-5462EFD2A8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983107" y="5172459"/>
                <a:ext cx="0" cy="79004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/>
              </a:extLst>
            </p:spPr>
            <p:txBody>
              <a:bodyPr/>
              <a:lstStyle/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kern="0">
                  <a:solidFill>
                    <a:srgbClr val="002F5D"/>
                  </a:solidFill>
                  <a:latin typeface="Arial" pitchFamily="34" charset="0"/>
                  <a:ea typeface="MS PGothic" pitchFamily="34" charset="-128"/>
                  <a:cs typeface="+mn-cs"/>
                </a:endParaRPr>
              </a:p>
            </p:txBody>
          </p:sp>
        </p:grp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68C89B6A-A4CA-3143-8691-2078412FA1AF}"/>
              </a:ext>
            </a:extLst>
          </p:cNvPr>
          <p:cNvGrpSpPr/>
          <p:nvPr/>
        </p:nvGrpSpPr>
        <p:grpSpPr>
          <a:xfrm>
            <a:off x="638099" y="833716"/>
            <a:ext cx="3291744" cy="2268779"/>
            <a:chOff x="3260502" y="652079"/>
            <a:chExt cx="3291744" cy="2268779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D1BA4669-2168-BB47-88CD-0766D94F50D2}"/>
                </a:ext>
              </a:extLst>
            </p:cNvPr>
            <p:cNvGrpSpPr/>
            <p:nvPr/>
          </p:nvGrpSpPr>
          <p:grpSpPr>
            <a:xfrm>
              <a:off x="3260502" y="652079"/>
              <a:ext cx="3291744" cy="2268779"/>
              <a:chOff x="3316700" y="210547"/>
              <a:chExt cx="3291744" cy="2268779"/>
            </a:xfrm>
          </p:grpSpPr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600096C9-A86F-1641-BDB9-E6D2B9F71709}"/>
                  </a:ext>
                </a:extLst>
              </p:cNvPr>
              <p:cNvGrpSpPr/>
              <p:nvPr/>
            </p:nvGrpSpPr>
            <p:grpSpPr>
              <a:xfrm>
                <a:off x="3316700" y="210547"/>
                <a:ext cx="3159906" cy="2268779"/>
                <a:chOff x="4528357" y="1098065"/>
                <a:chExt cx="3159906" cy="2268779"/>
              </a:xfrm>
            </p:grpSpPr>
            <p:pic>
              <p:nvPicPr>
                <p:cNvPr id="39" name="Picture 86">
                  <a:extLst>
                    <a:ext uri="{FF2B5EF4-FFF2-40B4-BE49-F238E27FC236}">
                      <a16:creationId xmlns:a16="http://schemas.microsoft.com/office/drawing/2014/main" id="{65CB58B1-68BB-4A40-B748-A0E87883E545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454775" y="1216025"/>
                  <a:ext cx="1233488" cy="11493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43" name="Picture 89">
                  <a:extLst>
                    <a:ext uri="{FF2B5EF4-FFF2-40B4-BE49-F238E27FC236}">
                      <a16:creationId xmlns:a16="http://schemas.microsoft.com/office/drawing/2014/main" id="{DB486226-93A5-C741-92B4-975E061B755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0253"/>
                <a:stretch/>
              </p:blipFill>
              <p:spPr bwMode="auto">
                <a:xfrm>
                  <a:off x="6480175" y="2124075"/>
                  <a:ext cx="1208088" cy="10272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44" name="Picture 85">
                  <a:extLst>
                    <a:ext uri="{FF2B5EF4-FFF2-40B4-BE49-F238E27FC236}">
                      <a16:creationId xmlns:a16="http://schemas.microsoft.com/office/drawing/2014/main" id="{9B427ED8-2361-EE4C-9F54-6B62D5B96F4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534025" y="1211263"/>
                  <a:ext cx="1228725" cy="11699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46" name="Picture 88">
                  <a:extLst>
                    <a:ext uri="{FF2B5EF4-FFF2-40B4-BE49-F238E27FC236}">
                      <a16:creationId xmlns:a16="http://schemas.microsoft.com/office/drawing/2014/main" id="{60F26027-3DB2-814A-A75F-3515D49F207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1177"/>
                <a:stretch/>
              </p:blipFill>
              <p:spPr bwMode="auto">
                <a:xfrm>
                  <a:off x="5538788" y="2109789"/>
                  <a:ext cx="1212850" cy="10335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47" name="Picture 84">
                  <a:extLst>
                    <a:ext uri="{FF2B5EF4-FFF2-40B4-BE49-F238E27FC236}">
                      <a16:creationId xmlns:a16="http://schemas.microsoft.com/office/drawing/2014/main" id="{9BA99256-8742-E449-B7CE-DCA63A7C376D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452"/>
                <a:stretch/>
              </p:blipFill>
              <p:spPr bwMode="auto">
                <a:xfrm>
                  <a:off x="4767159" y="1227138"/>
                  <a:ext cx="1047853" cy="1100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48" name="Picture 87">
                  <a:extLst>
                    <a:ext uri="{FF2B5EF4-FFF2-40B4-BE49-F238E27FC236}">
                      <a16:creationId xmlns:a16="http://schemas.microsoft.com/office/drawing/2014/main" id="{4FD8E54F-BB12-3947-ACEA-2DFAFA4C887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963" b="8254"/>
                <a:stretch/>
              </p:blipFill>
              <p:spPr bwMode="auto">
                <a:xfrm>
                  <a:off x="4778272" y="2135189"/>
                  <a:ext cx="1046266" cy="10209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49" name="Text Box 91">
                  <a:extLst>
                    <a:ext uri="{FF2B5EF4-FFF2-40B4-BE49-F238E27FC236}">
                      <a16:creationId xmlns:a16="http://schemas.microsoft.com/office/drawing/2014/main" id="{984A0FE4-7F13-5340-8F9B-AFF9B0D0629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808538" y="1592263"/>
                  <a:ext cx="36036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0.8%</a:t>
                  </a:r>
                </a:p>
              </p:txBody>
            </p:sp>
            <p:sp>
              <p:nvSpPr>
                <p:cNvPr id="50" name="Text Box 92">
                  <a:extLst>
                    <a:ext uri="{FF2B5EF4-FFF2-40B4-BE49-F238E27FC236}">
                      <a16:creationId xmlns:a16="http://schemas.microsoft.com/office/drawing/2014/main" id="{C614E235-1CCA-6E4D-AF7E-5C5F042ADF3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973638" y="1692275"/>
                  <a:ext cx="40481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53.5%</a:t>
                  </a:r>
                </a:p>
              </p:txBody>
            </p:sp>
            <p:sp>
              <p:nvSpPr>
                <p:cNvPr id="51" name="Text Box 93">
                  <a:extLst>
                    <a:ext uri="{FF2B5EF4-FFF2-40B4-BE49-F238E27FC236}">
                      <a16:creationId xmlns:a16="http://schemas.microsoft.com/office/drawing/2014/main" id="{6DEA3C60-BAF6-FA4B-9A91-2AB00F1C42B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260975" y="1884363"/>
                  <a:ext cx="496888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25.0%</a:t>
                  </a:r>
                </a:p>
              </p:txBody>
            </p:sp>
            <p:sp>
              <p:nvSpPr>
                <p:cNvPr id="52" name="Text Box 94">
                  <a:extLst>
                    <a:ext uri="{FF2B5EF4-FFF2-40B4-BE49-F238E27FC236}">
                      <a16:creationId xmlns:a16="http://schemas.microsoft.com/office/drawing/2014/main" id="{0DD5256C-F541-BC47-AF15-44F6D7D7375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221288" y="1344613"/>
                  <a:ext cx="36036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 dirty="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0.1%</a:t>
                  </a:r>
                </a:p>
              </p:txBody>
            </p:sp>
            <p:sp>
              <p:nvSpPr>
                <p:cNvPr id="53" name="Text Box 95">
                  <a:extLst>
                    <a:ext uri="{FF2B5EF4-FFF2-40B4-BE49-F238E27FC236}">
                      <a16:creationId xmlns:a16="http://schemas.microsoft.com/office/drawing/2014/main" id="{7D0FFBB9-8259-4B4D-9942-07D378B6832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816475" y="2473325"/>
                  <a:ext cx="36036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1.0%</a:t>
                  </a:r>
                </a:p>
              </p:txBody>
            </p:sp>
            <p:sp>
              <p:nvSpPr>
                <p:cNvPr id="54" name="Text Box 96">
                  <a:extLst>
                    <a:ext uri="{FF2B5EF4-FFF2-40B4-BE49-F238E27FC236}">
                      <a16:creationId xmlns:a16="http://schemas.microsoft.com/office/drawing/2014/main" id="{E3A83143-54C5-B04F-A68D-59B3F47EDE2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972050" y="2611438"/>
                  <a:ext cx="40481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36.5%</a:t>
                  </a:r>
                </a:p>
              </p:txBody>
            </p:sp>
            <p:sp>
              <p:nvSpPr>
                <p:cNvPr id="55" name="Text Box 97">
                  <a:extLst>
                    <a:ext uri="{FF2B5EF4-FFF2-40B4-BE49-F238E27FC236}">
                      <a16:creationId xmlns:a16="http://schemas.microsoft.com/office/drawing/2014/main" id="{D98BC4F4-33B7-9B4F-93D3-F1BF2186039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273675" y="2792413"/>
                  <a:ext cx="40481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30.3%</a:t>
                  </a:r>
                </a:p>
              </p:txBody>
            </p:sp>
            <p:sp>
              <p:nvSpPr>
                <p:cNvPr id="56" name="Text Box 98">
                  <a:extLst>
                    <a:ext uri="{FF2B5EF4-FFF2-40B4-BE49-F238E27FC236}">
                      <a16:creationId xmlns:a16="http://schemas.microsoft.com/office/drawing/2014/main" id="{543AC59E-4056-1D4B-8872-35C6F9650F2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264150" y="2252663"/>
                  <a:ext cx="36036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0.3%</a:t>
                  </a:r>
                </a:p>
              </p:txBody>
            </p:sp>
            <p:sp>
              <p:nvSpPr>
                <p:cNvPr id="57" name="Text Box 99">
                  <a:extLst>
                    <a:ext uri="{FF2B5EF4-FFF2-40B4-BE49-F238E27FC236}">
                      <a16:creationId xmlns:a16="http://schemas.microsoft.com/office/drawing/2014/main" id="{04FD2C67-979A-8F4A-BCB4-967799F13F0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715000" y="1592263"/>
                  <a:ext cx="36036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5.4%</a:t>
                  </a:r>
                </a:p>
              </p:txBody>
            </p:sp>
            <p:sp>
              <p:nvSpPr>
                <p:cNvPr id="58" name="Text Box 100">
                  <a:extLst>
                    <a:ext uri="{FF2B5EF4-FFF2-40B4-BE49-F238E27FC236}">
                      <a16:creationId xmlns:a16="http://schemas.microsoft.com/office/drawing/2014/main" id="{175E5661-B8A7-1E47-A4B6-330C2EB88B3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935663" y="1692275"/>
                  <a:ext cx="40481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28.1%</a:t>
                  </a:r>
                </a:p>
              </p:txBody>
            </p:sp>
            <p:sp>
              <p:nvSpPr>
                <p:cNvPr id="59" name="Text Box 101">
                  <a:extLst>
                    <a:ext uri="{FF2B5EF4-FFF2-40B4-BE49-F238E27FC236}">
                      <a16:creationId xmlns:a16="http://schemas.microsoft.com/office/drawing/2014/main" id="{6D98FDDB-9F47-B74B-8D6B-CA703C9870E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272213" y="1917700"/>
                  <a:ext cx="36036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2.7%</a:t>
                  </a:r>
                </a:p>
              </p:txBody>
            </p:sp>
            <p:sp>
              <p:nvSpPr>
                <p:cNvPr id="60" name="Text Box 102">
                  <a:extLst>
                    <a:ext uri="{FF2B5EF4-FFF2-40B4-BE49-F238E27FC236}">
                      <a16:creationId xmlns:a16="http://schemas.microsoft.com/office/drawing/2014/main" id="{2835BB46-9235-9D44-B4F4-CB196079233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119813" y="1343025"/>
                  <a:ext cx="40481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 dirty="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47.8%</a:t>
                  </a:r>
                </a:p>
              </p:txBody>
            </p:sp>
            <p:sp>
              <p:nvSpPr>
                <p:cNvPr id="61" name="Text Box 103">
                  <a:extLst>
                    <a:ext uri="{FF2B5EF4-FFF2-40B4-BE49-F238E27FC236}">
                      <a16:creationId xmlns:a16="http://schemas.microsoft.com/office/drawing/2014/main" id="{2A039E8D-0282-1A45-9BBF-56E46DA1CCF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722938" y="2466975"/>
                  <a:ext cx="36036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5.4%</a:t>
                  </a:r>
                </a:p>
              </p:txBody>
            </p:sp>
            <p:sp>
              <p:nvSpPr>
                <p:cNvPr id="62" name="Text Box 104">
                  <a:extLst>
                    <a:ext uri="{FF2B5EF4-FFF2-40B4-BE49-F238E27FC236}">
                      <a16:creationId xmlns:a16="http://schemas.microsoft.com/office/drawing/2014/main" id="{0F50DA77-2DEA-C24E-9036-C6265FD8F18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927725" y="2590800"/>
                  <a:ext cx="40481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 dirty="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20.3%</a:t>
                  </a:r>
                </a:p>
              </p:txBody>
            </p:sp>
            <p:sp>
              <p:nvSpPr>
                <p:cNvPr id="63" name="Text Box 105">
                  <a:extLst>
                    <a:ext uri="{FF2B5EF4-FFF2-40B4-BE49-F238E27FC236}">
                      <a16:creationId xmlns:a16="http://schemas.microsoft.com/office/drawing/2014/main" id="{D4C9365F-1027-554E-956D-A8AD2EB6109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256338" y="2814638"/>
                  <a:ext cx="36036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2.8%</a:t>
                  </a:r>
                </a:p>
              </p:txBody>
            </p:sp>
            <p:sp>
              <p:nvSpPr>
                <p:cNvPr id="64" name="Text Box 106">
                  <a:extLst>
                    <a:ext uri="{FF2B5EF4-FFF2-40B4-BE49-F238E27FC236}">
                      <a16:creationId xmlns:a16="http://schemas.microsoft.com/office/drawing/2014/main" id="{E4CE4C26-DBE4-1747-82D0-26481EC6069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124575" y="2235200"/>
                  <a:ext cx="430213" cy="188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48.4%</a:t>
                  </a:r>
                </a:p>
              </p:txBody>
            </p:sp>
            <p:sp>
              <p:nvSpPr>
                <p:cNvPr id="65" name="Text Box 107">
                  <a:extLst>
                    <a:ext uri="{FF2B5EF4-FFF2-40B4-BE49-F238E27FC236}">
                      <a16:creationId xmlns:a16="http://schemas.microsoft.com/office/drawing/2014/main" id="{9F459945-34B8-AB40-A22D-D5FED7C0C42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629400" y="1574800"/>
                  <a:ext cx="36036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1.1%</a:t>
                  </a:r>
                </a:p>
              </p:txBody>
            </p:sp>
            <p:sp>
              <p:nvSpPr>
                <p:cNvPr id="66" name="Text Box 108">
                  <a:extLst>
                    <a:ext uri="{FF2B5EF4-FFF2-40B4-BE49-F238E27FC236}">
                      <a16:creationId xmlns:a16="http://schemas.microsoft.com/office/drawing/2014/main" id="{32D23105-0C2A-8E46-A3EF-7F671A01B5C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826250" y="1706563"/>
                  <a:ext cx="40481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66.6%</a:t>
                  </a:r>
                </a:p>
              </p:txBody>
            </p:sp>
            <p:sp>
              <p:nvSpPr>
                <p:cNvPr id="67" name="Text Box 109">
                  <a:extLst>
                    <a:ext uri="{FF2B5EF4-FFF2-40B4-BE49-F238E27FC236}">
                      <a16:creationId xmlns:a16="http://schemas.microsoft.com/office/drawing/2014/main" id="{7881217F-91C0-594A-8096-9AA1BDDBA4A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223125" y="1914525"/>
                  <a:ext cx="36036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5.9%</a:t>
                  </a:r>
                </a:p>
              </p:txBody>
            </p:sp>
            <p:sp>
              <p:nvSpPr>
                <p:cNvPr id="68" name="Text Box 110">
                  <a:extLst>
                    <a:ext uri="{FF2B5EF4-FFF2-40B4-BE49-F238E27FC236}">
                      <a16:creationId xmlns:a16="http://schemas.microsoft.com/office/drawing/2014/main" id="{F2CA6556-A5B6-1040-B62D-4804AFB5045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86600" y="1347788"/>
                  <a:ext cx="420688" cy="2159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800" b="1" dirty="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9.1%</a:t>
                  </a:r>
                </a:p>
              </p:txBody>
            </p:sp>
            <p:sp>
              <p:nvSpPr>
                <p:cNvPr id="69" name="Text Box 111">
                  <a:extLst>
                    <a:ext uri="{FF2B5EF4-FFF2-40B4-BE49-F238E27FC236}">
                      <a16:creationId xmlns:a16="http://schemas.microsoft.com/office/drawing/2014/main" id="{628B316C-ADE9-CB46-9073-D3D82EB36F1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665913" y="2460625"/>
                  <a:ext cx="36036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3.7%</a:t>
                  </a:r>
                </a:p>
              </p:txBody>
            </p:sp>
            <p:sp>
              <p:nvSpPr>
                <p:cNvPr id="70" name="Text Box 112">
                  <a:extLst>
                    <a:ext uri="{FF2B5EF4-FFF2-40B4-BE49-F238E27FC236}">
                      <a16:creationId xmlns:a16="http://schemas.microsoft.com/office/drawing/2014/main" id="{D3B154A0-E86D-DB4C-8D24-EB5BD5210C1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850063" y="2590800"/>
                  <a:ext cx="404812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26.8%</a:t>
                  </a:r>
                </a:p>
              </p:txBody>
            </p:sp>
            <p:sp>
              <p:nvSpPr>
                <p:cNvPr id="71" name="Text Box 113">
                  <a:extLst>
                    <a:ext uri="{FF2B5EF4-FFF2-40B4-BE49-F238E27FC236}">
                      <a16:creationId xmlns:a16="http://schemas.microsoft.com/office/drawing/2014/main" id="{879C1034-5FE1-4C48-A8BE-6F64ADCF7C8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207250" y="2817813"/>
                  <a:ext cx="360363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600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4.7%</a:t>
                  </a:r>
                </a:p>
              </p:txBody>
            </p:sp>
            <p:sp>
              <p:nvSpPr>
                <p:cNvPr id="72" name="Text Box 114">
                  <a:extLst>
                    <a:ext uri="{FF2B5EF4-FFF2-40B4-BE49-F238E27FC236}">
                      <a16:creationId xmlns:a16="http://schemas.microsoft.com/office/drawing/2014/main" id="{9F7EC69C-20D8-6D40-A29E-C6B57D7B458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78663" y="2241550"/>
                  <a:ext cx="477837" cy="2159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latinLnBrk="0"/>
                  <a:r>
                    <a:rPr kumimoji="0" lang="en-US" altLang="ko-KR" sz="800" b="1">
                      <a:solidFill>
                        <a:srgbClr val="000066"/>
                      </a:solidFill>
                      <a:latin typeface="Arial" charset="0"/>
                      <a:cs typeface="Arial" charset="0"/>
                    </a:rPr>
                    <a:t>44.3%</a:t>
                  </a:r>
                </a:p>
              </p:txBody>
            </p:sp>
            <p:sp>
              <p:nvSpPr>
                <p:cNvPr id="73" name="Text Box 121">
                  <a:extLst>
                    <a:ext uri="{FF2B5EF4-FFF2-40B4-BE49-F238E27FC236}">
                      <a16:creationId xmlns:a16="http://schemas.microsoft.com/office/drawing/2014/main" id="{B2418D49-912D-7044-BAD8-F2404241A82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972495" y="1099583"/>
                  <a:ext cx="662361" cy="22892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eaLnBrk="1" latinLnBrk="0" hangingPunct="1"/>
                  <a:r>
                    <a:rPr kumimoji="0" lang="en-US" altLang="ko-KR" sz="1200" dirty="0" err="1">
                      <a:latin typeface="Arial" charset="0"/>
                    </a:rPr>
                    <a:t>Unstim</a:t>
                  </a:r>
                  <a:endParaRPr kumimoji="0" lang="en-US" altLang="ko-KR" sz="1200" dirty="0">
                    <a:latin typeface="Arial" charset="0"/>
                  </a:endParaRPr>
                </a:p>
              </p:txBody>
            </p:sp>
            <p:sp>
              <p:nvSpPr>
                <p:cNvPr id="74" name="Text Box 122">
                  <a:extLst>
                    <a:ext uri="{FF2B5EF4-FFF2-40B4-BE49-F238E27FC236}">
                      <a16:creationId xmlns:a16="http://schemas.microsoft.com/office/drawing/2014/main" id="{7C7D2998-4245-DD40-8B3A-96F4FD790F8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652181" y="1099583"/>
                  <a:ext cx="1075936" cy="27699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eaLnBrk="1" latinLnBrk="0" hangingPunct="1"/>
                  <a:r>
                    <a:rPr kumimoji="0" lang="en-US" altLang="ko-KR" sz="1200" dirty="0" err="1">
                      <a:latin typeface="Arial" charset="0"/>
                    </a:rPr>
                    <a:t>Stim+Control</a:t>
                  </a:r>
                  <a:endParaRPr kumimoji="0" lang="en-US" altLang="ko-KR" sz="1200" dirty="0">
                    <a:latin typeface="Arial" charset="0"/>
                  </a:endParaRPr>
                </a:p>
              </p:txBody>
            </p:sp>
            <p:sp>
              <p:nvSpPr>
                <p:cNvPr id="75" name="Text Box 123">
                  <a:extLst>
                    <a:ext uri="{FF2B5EF4-FFF2-40B4-BE49-F238E27FC236}">
                      <a16:creationId xmlns:a16="http://schemas.microsoft.com/office/drawing/2014/main" id="{EC591C9B-B9CF-5E46-A0FA-A0E2DE0AE9E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625760" y="1098065"/>
                  <a:ext cx="965488" cy="22959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1pPr>
                  <a:lvl2pPr marL="742950" indent="-28575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2pPr>
                  <a:lvl3pPr marL="11430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3pPr>
                  <a:lvl4pPr marL="16002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4pPr>
                  <a:lvl5pPr marL="2057400" indent="-228600" eaLnBrk="0" hangingPunct="0"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5pPr>
                  <a:lvl6pPr marL="25146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6pPr>
                  <a:lvl7pPr marL="29718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7pPr>
                  <a:lvl8pPr marL="34290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8pPr>
                  <a:lvl9pPr marL="3886200" indent="-228600" eaLnBrk="0" fontAlgn="base" latinLnBrk="1" hangingPunct="0">
                    <a:spcBef>
                      <a:spcPct val="0"/>
                    </a:spcBef>
                    <a:spcAft>
                      <a:spcPct val="0"/>
                    </a:spcAft>
                    <a:defRPr kumimoji="1" sz="2400">
                      <a:solidFill>
                        <a:schemeClr val="tx1"/>
                      </a:solidFill>
                      <a:latin typeface="굴림" charset="0"/>
                      <a:ea typeface="굴림" charset="0"/>
                      <a:cs typeface="굴림" charset="0"/>
                    </a:defRPr>
                  </a:lvl9pPr>
                </a:lstStyle>
                <a:p>
                  <a:pPr eaLnBrk="1" latinLnBrk="0" hangingPunct="1"/>
                  <a:r>
                    <a:rPr kumimoji="0" lang="en-US" altLang="ko-KR" sz="1200" dirty="0" err="1">
                      <a:latin typeface="Arial" charset="0"/>
                    </a:rPr>
                    <a:t>Stim+TGF-</a:t>
                  </a:r>
                  <a:r>
                    <a:rPr kumimoji="0" lang="en-US" altLang="ko-KR" sz="1200" dirty="0" err="1">
                      <a:latin typeface="Symbol" charset="0"/>
                    </a:rPr>
                    <a:t>b</a:t>
                  </a:r>
                  <a:endParaRPr kumimoji="0" lang="en-US" altLang="ko-KR" sz="1200" dirty="0">
                    <a:latin typeface="Symbol" charset="0"/>
                  </a:endParaRPr>
                </a:p>
              </p:txBody>
            </p:sp>
            <p:sp>
              <p:nvSpPr>
                <p:cNvPr id="76" name="Rectangle 21">
                  <a:extLst>
                    <a:ext uri="{FF2B5EF4-FFF2-40B4-BE49-F238E27FC236}">
                      <a16:creationId xmlns:a16="http://schemas.microsoft.com/office/drawing/2014/main" id="{5AB7FE99-F812-D54C-87C5-FF337C29D0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51728" y="3137843"/>
                  <a:ext cx="993598" cy="22900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anchor="ctr"/>
                <a:lstStyle/>
                <a:p>
                  <a:pPr algn="ctr"/>
                  <a:r>
                    <a:rPr lang="en-US" altLang="ko-KR" sz="1100" dirty="0">
                      <a:latin typeface="Arial" charset="0"/>
                      <a:cs typeface="Arial" charset="0"/>
                    </a:rPr>
                    <a:t>7AAD</a:t>
                  </a:r>
                </a:p>
              </p:txBody>
            </p:sp>
            <p:sp>
              <p:nvSpPr>
                <p:cNvPr id="77" name="Line 22">
                  <a:extLst>
                    <a:ext uri="{FF2B5EF4-FFF2-40B4-BE49-F238E27FC236}">
                      <a16:creationId xmlns:a16="http://schemas.microsoft.com/office/drawing/2014/main" id="{8C4EAF01-C538-8C43-AA40-FC2BF4F124D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740482" y="3171825"/>
                  <a:ext cx="276875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=""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78" name="Rectangle 24">
                  <a:extLst>
                    <a:ext uri="{FF2B5EF4-FFF2-40B4-BE49-F238E27FC236}">
                      <a16:creationId xmlns:a16="http://schemas.microsoft.com/office/drawing/2014/main" id="{66A796E2-1B8B-6B46-9771-FBE4EA3C67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312">
                  <a:off x="4345453" y="2074430"/>
                  <a:ext cx="615085" cy="24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anchor="ctr"/>
                <a:lstStyle/>
                <a:p>
                  <a:pPr algn="ctr"/>
                  <a:r>
                    <a:rPr lang="en-US" altLang="ko-KR" sz="1100" dirty="0" err="1">
                      <a:latin typeface="Arial" charset="0"/>
                      <a:cs typeface="Arial" charset="0"/>
                    </a:rPr>
                    <a:t>BrdU</a:t>
                  </a:r>
                  <a:endParaRPr lang="en-US" altLang="ko-KR" sz="1100" dirty="0">
                    <a:latin typeface="Symbol" charset="0"/>
                    <a:cs typeface="Arial" charset="0"/>
                  </a:endParaRPr>
                </a:p>
              </p:txBody>
            </p:sp>
          </p:grpSp>
          <p:sp>
            <p:nvSpPr>
              <p:cNvPr id="37" name="TextBox 17">
                <a:extLst>
                  <a:ext uri="{FF2B5EF4-FFF2-40B4-BE49-F238E27FC236}">
                    <a16:creationId xmlns:a16="http://schemas.microsoft.com/office/drawing/2014/main" id="{4045F359-16CE-6A46-B84F-2E6E4890E5C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5999806" y="1608558"/>
                <a:ext cx="930619" cy="2866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9pPr>
              </a:lstStyle>
              <a:p>
                <a:pPr algn="ctr" eaLnBrk="1" hangingPunct="1"/>
                <a:r>
                  <a:rPr lang="en-US" sz="1200" dirty="0"/>
                  <a:t>Smad4</a:t>
                </a:r>
                <a:r>
                  <a:rPr lang="en-US" sz="1200" baseline="30000" dirty="0"/>
                  <a:t>TKO</a:t>
                </a:r>
                <a:endParaRPr lang="en-US" sz="1200" dirty="0"/>
              </a:p>
            </p:txBody>
          </p:sp>
          <p:sp>
            <p:nvSpPr>
              <p:cNvPr id="38" name="TextBox 17">
                <a:extLst>
                  <a:ext uri="{FF2B5EF4-FFF2-40B4-BE49-F238E27FC236}">
                    <a16:creationId xmlns:a16="http://schemas.microsoft.com/office/drawing/2014/main" id="{57A47B2E-16AC-4648-A50C-92C4C164011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5997240" y="739002"/>
                <a:ext cx="93061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9pPr>
              </a:lstStyle>
              <a:p>
                <a:pPr algn="ctr" eaLnBrk="1" hangingPunct="1"/>
                <a:r>
                  <a:rPr lang="en-US" sz="1200" dirty="0"/>
                  <a:t>WT</a:t>
                </a:r>
              </a:p>
            </p:txBody>
          </p:sp>
        </p:grpSp>
        <p:sp>
          <p:nvSpPr>
            <p:cNvPr id="33" name="Line 23">
              <a:extLst>
                <a:ext uri="{FF2B5EF4-FFF2-40B4-BE49-F238E27FC236}">
                  <a16:creationId xmlns:a16="http://schemas.microsoft.com/office/drawing/2014/main" id="{8272D5A2-4DDB-D44E-B364-157B17C7A1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2627" y="1187610"/>
              <a:ext cx="0" cy="154586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8361710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3"/>
          <p:cNvSpPr>
            <a:spLocks noChangeArrowheads="1"/>
          </p:cNvSpPr>
          <p:nvPr/>
        </p:nvSpPr>
        <p:spPr bwMode="auto">
          <a:xfrm>
            <a:off x="6751" y="6750"/>
            <a:ext cx="3024316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579438" indent="-579438" algn="ctr" latinLnBrk="0">
              <a:spcBef>
                <a:spcPct val="20000"/>
              </a:spcBef>
            </a:pPr>
            <a:r>
              <a:rPr lang="en-US" altLang="ko-KR" dirty="0">
                <a:solidFill>
                  <a:srgbClr val="003366"/>
                </a:solidFill>
                <a:latin typeface="Arial" charset="0"/>
              </a:rPr>
              <a:t>Supplementary F</a:t>
            </a:r>
            <a:r>
              <a:rPr kumimoji="0" lang="en-US" altLang="ko-KR" sz="1800" dirty="0">
                <a:solidFill>
                  <a:srgbClr val="003366"/>
                </a:solidFill>
                <a:latin typeface="Arial" charset="0"/>
              </a:rPr>
              <a:t>igure 2</a:t>
            </a:r>
          </a:p>
        </p:txBody>
      </p:sp>
      <p:sp>
        <p:nvSpPr>
          <p:cNvPr id="132" name="Rectangle 3"/>
          <p:cNvSpPr>
            <a:spLocks noChangeArrowheads="1"/>
          </p:cNvSpPr>
          <p:nvPr/>
        </p:nvSpPr>
        <p:spPr bwMode="auto">
          <a:xfrm>
            <a:off x="133297" y="685380"/>
            <a:ext cx="4572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579438" indent="-579438" algn="ctr" latinLnBrk="0">
              <a:spcBef>
                <a:spcPct val="20000"/>
              </a:spcBef>
            </a:pPr>
            <a:r>
              <a:rPr kumimoji="0" lang="en-US" altLang="ko-KR" sz="1800" b="1" dirty="0">
                <a:latin typeface="Arial" charset="0"/>
              </a:rPr>
              <a:t>A</a:t>
            </a:r>
          </a:p>
        </p:txBody>
      </p:sp>
      <p:sp>
        <p:nvSpPr>
          <p:cNvPr id="133" name="Rectangle 3"/>
          <p:cNvSpPr>
            <a:spLocks noChangeArrowheads="1"/>
          </p:cNvSpPr>
          <p:nvPr/>
        </p:nvSpPr>
        <p:spPr bwMode="auto">
          <a:xfrm>
            <a:off x="133297" y="3460258"/>
            <a:ext cx="4572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579438" indent="-579438" algn="ctr" latinLnBrk="0">
              <a:spcBef>
                <a:spcPct val="20000"/>
              </a:spcBef>
            </a:pPr>
            <a:r>
              <a:rPr kumimoji="0" lang="en-US" altLang="ko-KR" sz="1800" b="1" dirty="0">
                <a:latin typeface="Arial" charset="0"/>
              </a:rPr>
              <a:t>B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73F4522-2FC3-C04E-AF94-3631A21D2420}"/>
              </a:ext>
            </a:extLst>
          </p:cNvPr>
          <p:cNvGrpSpPr/>
          <p:nvPr/>
        </p:nvGrpSpPr>
        <p:grpSpPr>
          <a:xfrm>
            <a:off x="355027" y="3970866"/>
            <a:ext cx="2473702" cy="2095080"/>
            <a:chOff x="3721275" y="1915389"/>
            <a:chExt cx="2473702" cy="2095080"/>
          </a:xfrm>
        </p:grpSpPr>
        <p:pic>
          <p:nvPicPr>
            <p:cNvPr id="113" name="Picture 19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21"/>
            <a:stretch/>
          </p:blipFill>
          <p:spPr bwMode="auto">
            <a:xfrm>
              <a:off x="5067657" y="1915389"/>
              <a:ext cx="917576" cy="1176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" name="Picture 20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21" b="25641"/>
            <a:stretch/>
          </p:blipFill>
          <p:spPr bwMode="auto">
            <a:xfrm>
              <a:off x="5067657" y="2725015"/>
              <a:ext cx="917576" cy="874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" name="Picture 11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62" b="19393"/>
            <a:stretch/>
          </p:blipFill>
          <p:spPr bwMode="auto">
            <a:xfrm>
              <a:off x="3956479" y="1916976"/>
              <a:ext cx="947666" cy="948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" name="Picture 8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62" b="25371"/>
            <a:stretch/>
          </p:blipFill>
          <p:spPr bwMode="auto">
            <a:xfrm>
              <a:off x="3956479" y="2721839"/>
              <a:ext cx="947666" cy="877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7" name="Rectangle 21"/>
            <p:cNvSpPr>
              <a:spLocks noChangeArrowheads="1"/>
            </p:cNvSpPr>
            <p:nvPr/>
          </p:nvSpPr>
          <p:spPr bwMode="auto">
            <a:xfrm>
              <a:off x="3911958" y="3558451"/>
              <a:ext cx="16002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/>
              <a:r>
                <a:rPr lang="en-US" altLang="ko-KR" sz="1100">
                  <a:latin typeface="Arial" charset="0"/>
                  <a:cs typeface="Arial" charset="0"/>
                </a:rPr>
                <a:t>CD4</a:t>
              </a:r>
            </a:p>
          </p:txBody>
        </p:sp>
        <p:sp>
          <p:nvSpPr>
            <p:cNvPr id="118" name="Line 22"/>
            <p:cNvSpPr>
              <a:spLocks noChangeShapeType="1"/>
            </p:cNvSpPr>
            <p:nvPr/>
          </p:nvSpPr>
          <p:spPr bwMode="auto">
            <a:xfrm flipV="1">
              <a:off x="4015145" y="3602901"/>
              <a:ext cx="142081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9" name="Rectangle 24"/>
            <p:cNvSpPr>
              <a:spLocks noChangeArrowheads="1"/>
            </p:cNvSpPr>
            <p:nvPr/>
          </p:nvSpPr>
          <p:spPr bwMode="auto">
            <a:xfrm rot="16200312">
              <a:off x="3391869" y="2701995"/>
              <a:ext cx="990600" cy="3317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/>
              <a:r>
                <a:rPr lang="en-US" altLang="ko-KR" sz="1100" dirty="0">
                  <a:latin typeface="Arial" charset="0"/>
                  <a:cs typeface="Arial" charset="0"/>
                </a:rPr>
                <a:t>IFN-</a:t>
              </a:r>
              <a:r>
                <a:rPr lang="en-US" altLang="ko-KR" sz="1100" dirty="0">
                  <a:latin typeface="Symbol" charset="0"/>
                  <a:cs typeface="Arial" charset="0"/>
                </a:rPr>
                <a:t>g</a:t>
              </a:r>
            </a:p>
          </p:txBody>
        </p:sp>
        <p:sp>
          <p:nvSpPr>
            <p:cNvPr id="121" name="Rectangle 24"/>
            <p:cNvSpPr>
              <a:spLocks noChangeArrowheads="1"/>
            </p:cNvSpPr>
            <p:nvPr/>
          </p:nvSpPr>
          <p:spPr bwMode="auto">
            <a:xfrm rot="16200312">
              <a:off x="4487687" y="2700407"/>
              <a:ext cx="990600" cy="3317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/>
              <a:r>
                <a:rPr lang="en-US" altLang="ko-KR" sz="1100" dirty="0">
                  <a:latin typeface="Arial" charset="0"/>
                  <a:cs typeface="Arial" charset="0"/>
                </a:rPr>
                <a:t>IL-6</a:t>
              </a:r>
              <a:endParaRPr lang="en-US" altLang="ko-KR" sz="1100" dirty="0">
                <a:latin typeface="Symbol" charset="0"/>
                <a:cs typeface="Arial" charset="0"/>
              </a:endParaRPr>
            </a:p>
          </p:txBody>
        </p:sp>
        <p:sp>
          <p:nvSpPr>
            <p:cNvPr id="125" name="Text Box 23"/>
            <p:cNvSpPr txBox="1">
              <a:spLocks noChangeArrowheads="1"/>
            </p:cNvSpPr>
            <p:nvPr/>
          </p:nvSpPr>
          <p:spPr bwMode="auto">
            <a:xfrm>
              <a:off x="5509704" y="3588783"/>
              <a:ext cx="46679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altLang="ko-KR" sz="1100" dirty="0">
                  <a:solidFill>
                    <a:srgbClr val="663300"/>
                  </a:solidFill>
                  <a:latin typeface="Arial" charset="0"/>
                  <a:cs typeface="Arial" charset="0"/>
                </a:rPr>
                <a:t>8Mo</a:t>
              </a:r>
            </a:p>
          </p:txBody>
        </p:sp>
        <p:sp>
          <p:nvSpPr>
            <p:cNvPr id="126" name="Text Box 13"/>
            <p:cNvSpPr txBox="1">
              <a:spLocks noChangeArrowheads="1"/>
            </p:cNvSpPr>
            <p:nvPr/>
          </p:nvSpPr>
          <p:spPr bwMode="auto">
            <a:xfrm>
              <a:off x="5468927" y="3733470"/>
              <a:ext cx="5501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200" dirty="0">
                  <a:solidFill>
                    <a:srgbClr val="333399"/>
                  </a:solidFill>
                  <a:latin typeface="Arial" charset="0"/>
                  <a:cs typeface="Arial" charset="0"/>
                </a:rPr>
                <a:t>colon</a:t>
              </a:r>
            </a:p>
          </p:txBody>
        </p:sp>
        <p:sp>
          <p:nvSpPr>
            <p:cNvPr id="130" name="TextBox 17"/>
            <p:cNvSpPr txBox="1">
              <a:spLocks noChangeArrowheads="1"/>
            </p:cNvSpPr>
            <p:nvPr/>
          </p:nvSpPr>
          <p:spPr bwMode="auto">
            <a:xfrm rot="16200000">
              <a:off x="5586339" y="2972077"/>
              <a:ext cx="930619" cy="286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9pPr>
            </a:lstStyle>
            <a:p>
              <a:pPr algn="ctr" eaLnBrk="1" hangingPunct="1"/>
              <a:r>
                <a:rPr lang="en-US" sz="1200" dirty="0"/>
                <a:t>Smad4</a:t>
              </a:r>
              <a:r>
                <a:rPr lang="en-US" sz="1200" baseline="30000" dirty="0"/>
                <a:t>TKO</a:t>
              </a:r>
              <a:endParaRPr lang="en-US" sz="1200" dirty="0"/>
            </a:p>
          </p:txBody>
        </p:sp>
        <p:sp>
          <p:nvSpPr>
            <p:cNvPr id="131" name="TextBox 17"/>
            <p:cNvSpPr txBox="1">
              <a:spLocks noChangeArrowheads="1"/>
            </p:cNvSpPr>
            <p:nvPr/>
          </p:nvSpPr>
          <p:spPr bwMode="auto">
            <a:xfrm rot="16200000">
              <a:off x="5664529" y="2161513"/>
              <a:ext cx="76910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9pPr>
            </a:lstStyle>
            <a:p>
              <a:pPr algn="ctr" eaLnBrk="1" hangingPunct="1"/>
              <a:r>
                <a:rPr lang="en-US" sz="1200" dirty="0"/>
                <a:t>WT</a:t>
              </a:r>
            </a:p>
          </p:txBody>
        </p:sp>
        <p:sp>
          <p:nvSpPr>
            <p:cNvPr id="43" name="Line 23">
              <a:extLst>
                <a:ext uri="{FF2B5EF4-FFF2-40B4-BE49-F238E27FC236}">
                  <a16:creationId xmlns:a16="http://schemas.microsoft.com/office/drawing/2014/main" id="{013A5EBB-39E4-1E41-BF98-32B1FA3747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5145" y="2057227"/>
              <a:ext cx="0" cy="154586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4" name="Line 23">
              <a:extLst>
                <a:ext uri="{FF2B5EF4-FFF2-40B4-BE49-F238E27FC236}">
                  <a16:creationId xmlns:a16="http://schemas.microsoft.com/office/drawing/2014/main" id="{33AE8B01-719E-0948-9706-2F19BF0A1E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67936" y="2053857"/>
              <a:ext cx="0" cy="154586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F40A4D6C-7433-B847-8732-1B9AD3C435F9}"/>
              </a:ext>
            </a:extLst>
          </p:cNvPr>
          <p:cNvGrpSpPr/>
          <p:nvPr/>
        </p:nvGrpSpPr>
        <p:grpSpPr>
          <a:xfrm>
            <a:off x="2903652" y="3726775"/>
            <a:ext cx="2197779" cy="2194672"/>
            <a:chOff x="2869784" y="4351762"/>
            <a:chExt cx="2197779" cy="2194672"/>
          </a:xfrm>
        </p:grpSpPr>
        <p:graphicFrame>
          <p:nvGraphicFramePr>
            <p:cNvPr id="59" name="Chart 58">
              <a:extLst>
                <a:ext uri="{FF2B5EF4-FFF2-40B4-BE49-F238E27FC236}">
                  <a16:creationId xmlns:a16="http://schemas.microsoft.com/office/drawing/2014/main" id="{72473C9D-13DF-2B48-8A29-1CC32A089E3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62691314"/>
                </p:ext>
              </p:extLst>
            </p:nvPr>
          </p:nvGraphicFramePr>
          <p:xfrm>
            <a:off x="2869784" y="4351762"/>
            <a:ext cx="2197779" cy="21946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60" name="TextBox 74">
              <a:extLst>
                <a:ext uri="{FF2B5EF4-FFF2-40B4-BE49-F238E27FC236}">
                  <a16:creationId xmlns:a16="http://schemas.microsoft.com/office/drawing/2014/main" id="{26F10B08-93AB-AE45-8C0B-DB2C25C9F0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67928" y="4966019"/>
              <a:ext cx="349933" cy="2017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charset="0"/>
                  <a:cs typeface="Arial" charset="0"/>
                </a:rPr>
                <a:t>**</a:t>
              </a:r>
            </a:p>
          </p:txBody>
        </p:sp>
        <p:sp>
          <p:nvSpPr>
            <p:cNvPr id="61" name="Left Bracket 60">
              <a:extLst>
                <a:ext uri="{FF2B5EF4-FFF2-40B4-BE49-F238E27FC236}">
                  <a16:creationId xmlns:a16="http://schemas.microsoft.com/office/drawing/2014/main" id="{24969D51-C355-1946-A9F5-B977916F02B6}"/>
                </a:ext>
              </a:extLst>
            </p:cNvPr>
            <p:cNvSpPr/>
            <p:nvPr/>
          </p:nvSpPr>
          <p:spPr bwMode="auto">
            <a:xfrm rot="5400000">
              <a:off x="3799531" y="5058009"/>
              <a:ext cx="30557" cy="20613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lIns="82058" tIns="41029" rIns="82058" bIns="41029" anchor="ctr"/>
            <a:lstStyle/>
            <a:p>
              <a:pPr algn="ctr" eaLnBrk="1" hangingPunct="1"/>
              <a:endParaRPr lang="en-US">
                <a:latin typeface="Arial" charset="0"/>
                <a:ea typeface="MS PGothic" charset="0"/>
                <a:cs typeface="MS PGothic" charset="0"/>
              </a:endParaRPr>
            </a:p>
          </p:txBody>
        </p:sp>
        <p:sp>
          <p:nvSpPr>
            <p:cNvPr id="62" name="TextBox 74">
              <a:extLst>
                <a:ext uri="{FF2B5EF4-FFF2-40B4-BE49-F238E27FC236}">
                  <a16:creationId xmlns:a16="http://schemas.microsoft.com/office/drawing/2014/main" id="{B7E5CA04-315E-7146-95CD-732AA28287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89895" y="4806650"/>
              <a:ext cx="349933" cy="2017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charset="0"/>
                  <a:cs typeface="Arial" charset="0"/>
                </a:rPr>
                <a:t>**</a:t>
              </a:r>
            </a:p>
          </p:txBody>
        </p:sp>
        <p:sp>
          <p:nvSpPr>
            <p:cNvPr id="63" name="Left Bracket 62">
              <a:extLst>
                <a:ext uri="{FF2B5EF4-FFF2-40B4-BE49-F238E27FC236}">
                  <a16:creationId xmlns:a16="http://schemas.microsoft.com/office/drawing/2014/main" id="{60C2B5E9-54C8-EF40-9C97-002FD34BDCC6}"/>
                </a:ext>
              </a:extLst>
            </p:cNvPr>
            <p:cNvSpPr/>
            <p:nvPr/>
          </p:nvSpPr>
          <p:spPr bwMode="auto">
            <a:xfrm rot="5400000">
              <a:off x="4537063" y="4898640"/>
              <a:ext cx="27779" cy="20613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lIns="82058" tIns="41029" rIns="82058" bIns="41029" anchor="ctr"/>
            <a:lstStyle/>
            <a:p>
              <a:pPr algn="ctr" eaLnBrk="1" hangingPunct="1"/>
              <a:endParaRPr lang="en-US">
                <a:latin typeface="Arial" charset="0"/>
                <a:ea typeface="MS PGothic" charset="0"/>
                <a:cs typeface="MS PGothic" charset="0"/>
              </a:endParaRP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06891B2-B895-3D4E-A557-D07A4EB7F8AB}"/>
              </a:ext>
            </a:extLst>
          </p:cNvPr>
          <p:cNvGrpSpPr/>
          <p:nvPr/>
        </p:nvGrpSpPr>
        <p:grpSpPr>
          <a:xfrm>
            <a:off x="299536" y="838774"/>
            <a:ext cx="2914184" cy="2443205"/>
            <a:chOff x="210011" y="1439908"/>
            <a:chExt cx="2914184" cy="2443205"/>
          </a:xfrm>
        </p:grpSpPr>
        <p:grpSp>
          <p:nvGrpSpPr>
            <p:cNvPr id="127" name="Group 1"/>
            <p:cNvGrpSpPr>
              <a:grpSpLocks/>
            </p:cNvGrpSpPr>
            <p:nvPr/>
          </p:nvGrpSpPr>
          <p:grpSpPr bwMode="auto">
            <a:xfrm>
              <a:off x="210011" y="1439908"/>
              <a:ext cx="2914184" cy="2443205"/>
              <a:chOff x="381000" y="609600"/>
              <a:chExt cx="3733800" cy="2525654"/>
            </a:xfrm>
          </p:grpSpPr>
          <p:sp>
            <p:nvSpPr>
              <p:cNvPr id="128" name="TextBox 26"/>
              <p:cNvSpPr txBox="1">
                <a:spLocks noChangeArrowheads="1"/>
              </p:cNvSpPr>
              <p:nvPr/>
            </p:nvSpPr>
            <p:spPr bwMode="auto">
              <a:xfrm>
                <a:off x="1204428" y="2864816"/>
                <a:ext cx="2553253" cy="2704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9pPr>
              </a:lstStyle>
              <a:p>
                <a:pPr eaLnBrk="1" hangingPunct="1"/>
                <a:r>
                  <a:rPr lang="en-US" sz="1100" dirty="0">
                    <a:latin typeface="Arial" charset="0"/>
                    <a:ea typeface="Arial" charset="0"/>
                    <a:cs typeface="Arial" charset="0"/>
                  </a:rPr>
                  <a:t>IFN-</a:t>
                </a:r>
                <a:r>
                  <a:rPr lang="en-US" sz="1100" dirty="0">
                    <a:latin typeface="Symbol" charset="2"/>
                    <a:ea typeface="Symbol" charset="2"/>
                    <a:cs typeface="Symbol" charset="2"/>
                  </a:rPr>
                  <a:t>g</a:t>
                </a:r>
                <a:r>
                  <a:rPr lang="en-US" sz="1100" dirty="0">
                    <a:latin typeface="Arial" charset="0"/>
                    <a:ea typeface="Arial" charset="0"/>
                    <a:cs typeface="Arial" charset="0"/>
                  </a:rPr>
                  <a:t>        TNF-</a:t>
                </a:r>
                <a:r>
                  <a:rPr lang="en-US" sz="1100" dirty="0">
                    <a:latin typeface="Symbol" charset="2"/>
                    <a:ea typeface="Symbol" charset="2"/>
                    <a:cs typeface="Symbol" charset="2"/>
                  </a:rPr>
                  <a:t>a</a:t>
                </a:r>
                <a:r>
                  <a:rPr lang="en-US" sz="1100" dirty="0">
                    <a:latin typeface="Arial" charset="0"/>
                    <a:ea typeface="Arial" charset="0"/>
                    <a:cs typeface="Arial" charset="0"/>
                  </a:rPr>
                  <a:t>          IL-6</a:t>
                </a:r>
              </a:p>
            </p:txBody>
          </p:sp>
          <p:graphicFrame>
            <p:nvGraphicFramePr>
              <p:cNvPr id="129" name="Chart 12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56390786"/>
                  </p:ext>
                </p:extLst>
              </p:nvPr>
            </p:nvGraphicFramePr>
            <p:xfrm>
              <a:off x="381000" y="609600"/>
              <a:ext cx="3733800" cy="238910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</p:grpSp>
        <p:sp>
          <p:nvSpPr>
            <p:cNvPr id="36" name="TextBox 74">
              <a:extLst>
                <a:ext uri="{FF2B5EF4-FFF2-40B4-BE49-F238E27FC236}">
                  <a16:creationId xmlns:a16="http://schemas.microsoft.com/office/drawing/2014/main" id="{9A7BB7B9-8973-2840-9346-1FC7333E36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9175" y="2104542"/>
              <a:ext cx="349933" cy="2017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charset="0"/>
                  <a:cs typeface="Arial" charset="0"/>
                </a:rPr>
                <a:t>**</a:t>
              </a:r>
            </a:p>
          </p:txBody>
        </p:sp>
        <p:sp>
          <p:nvSpPr>
            <p:cNvPr id="37" name="Left Bracket 36">
              <a:extLst>
                <a:ext uri="{FF2B5EF4-FFF2-40B4-BE49-F238E27FC236}">
                  <a16:creationId xmlns:a16="http://schemas.microsoft.com/office/drawing/2014/main" id="{76A6AA9C-C1D6-E946-8298-83E931282C3D}"/>
                </a:ext>
              </a:extLst>
            </p:cNvPr>
            <p:cNvSpPr/>
            <p:nvPr/>
          </p:nvSpPr>
          <p:spPr bwMode="auto">
            <a:xfrm rot="5400000">
              <a:off x="1090778" y="2196532"/>
              <a:ext cx="30557" cy="20613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lIns="82058" tIns="41029" rIns="82058" bIns="41029" anchor="ctr"/>
            <a:lstStyle/>
            <a:p>
              <a:pPr algn="ctr" eaLnBrk="1" hangingPunct="1"/>
              <a:endParaRPr lang="en-US">
                <a:latin typeface="Arial" charset="0"/>
                <a:ea typeface="MS PGothic" charset="0"/>
                <a:cs typeface="MS PGothic" charset="0"/>
              </a:endParaRPr>
            </a:p>
          </p:txBody>
        </p:sp>
        <p:sp>
          <p:nvSpPr>
            <p:cNvPr id="38" name="TextBox 74">
              <a:extLst>
                <a:ext uri="{FF2B5EF4-FFF2-40B4-BE49-F238E27FC236}">
                  <a16:creationId xmlns:a16="http://schemas.microsoft.com/office/drawing/2014/main" id="{62632F4D-12CE-9E45-837F-890420A4EE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30422" y="1649329"/>
              <a:ext cx="349933" cy="2017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charset="0"/>
                  <a:cs typeface="Arial" charset="0"/>
                </a:rPr>
                <a:t>**</a:t>
              </a:r>
            </a:p>
          </p:txBody>
        </p:sp>
        <p:sp>
          <p:nvSpPr>
            <p:cNvPr id="39" name="Left Bracket 38">
              <a:extLst>
                <a:ext uri="{FF2B5EF4-FFF2-40B4-BE49-F238E27FC236}">
                  <a16:creationId xmlns:a16="http://schemas.microsoft.com/office/drawing/2014/main" id="{E756E74B-B421-F148-897F-430765589F1A}"/>
                </a:ext>
              </a:extLst>
            </p:cNvPr>
            <p:cNvSpPr/>
            <p:nvPr/>
          </p:nvSpPr>
          <p:spPr bwMode="auto">
            <a:xfrm rot="5400000">
              <a:off x="2462025" y="1741319"/>
              <a:ext cx="30557" cy="20613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lIns="82058" tIns="41029" rIns="82058" bIns="41029" anchor="ctr"/>
            <a:lstStyle/>
            <a:p>
              <a:pPr algn="ctr" eaLnBrk="1" hangingPunct="1"/>
              <a:endParaRPr lang="en-US">
                <a:latin typeface="Arial" charset="0"/>
                <a:ea typeface="MS PGothic" charset="0"/>
                <a:cs typeface="MS PGothic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143896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3"/>
          <p:cNvSpPr>
            <a:spLocks noChangeArrowheads="1"/>
          </p:cNvSpPr>
          <p:nvPr/>
        </p:nvSpPr>
        <p:spPr bwMode="auto">
          <a:xfrm>
            <a:off x="6751" y="6750"/>
            <a:ext cx="3055012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579438" indent="-579438" algn="ctr" latinLnBrk="0">
              <a:spcBef>
                <a:spcPct val="20000"/>
              </a:spcBef>
            </a:pPr>
            <a:r>
              <a:rPr lang="en-US" altLang="ko-KR" dirty="0">
                <a:solidFill>
                  <a:srgbClr val="003366"/>
                </a:solidFill>
                <a:latin typeface="Arial" charset="0"/>
              </a:rPr>
              <a:t>Supplementary F</a:t>
            </a:r>
            <a:r>
              <a:rPr kumimoji="0" lang="en-US" altLang="ko-KR" sz="1800" dirty="0">
                <a:solidFill>
                  <a:srgbClr val="003366"/>
                </a:solidFill>
                <a:latin typeface="Arial" charset="0"/>
              </a:rPr>
              <a:t>igure 3</a:t>
            </a:r>
          </a:p>
        </p:txBody>
      </p:sp>
      <p:sp>
        <p:nvSpPr>
          <p:cNvPr id="204" name="TextBox 203"/>
          <p:cNvSpPr txBox="1">
            <a:spLocks noChangeArrowheads="1"/>
          </p:cNvSpPr>
          <p:nvPr/>
        </p:nvSpPr>
        <p:spPr bwMode="auto">
          <a:xfrm>
            <a:off x="194728" y="855702"/>
            <a:ext cx="3635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800" b="1" dirty="0"/>
              <a:t>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B764B776-3E3F-7A41-A43D-3DFFEB42AE7B}"/>
              </a:ext>
            </a:extLst>
          </p:cNvPr>
          <p:cNvGrpSpPr/>
          <p:nvPr/>
        </p:nvGrpSpPr>
        <p:grpSpPr>
          <a:xfrm>
            <a:off x="259106" y="949299"/>
            <a:ext cx="5382144" cy="2603481"/>
            <a:chOff x="259106" y="949299"/>
            <a:chExt cx="5382144" cy="2603481"/>
          </a:xfrm>
        </p:grpSpPr>
        <p:pic>
          <p:nvPicPr>
            <p:cNvPr id="81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2" r="86288" b="18310"/>
            <a:stretch/>
          </p:blipFill>
          <p:spPr bwMode="auto">
            <a:xfrm>
              <a:off x="578019" y="1181810"/>
              <a:ext cx="1169763" cy="1217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2" name="Picture 81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27" r="49328" b="18779"/>
            <a:stretch/>
          </p:blipFill>
          <p:spPr bwMode="auto">
            <a:xfrm>
              <a:off x="1670269" y="1172945"/>
              <a:ext cx="1194658" cy="1210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3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357" r="24878" b="17958"/>
            <a:stretch/>
          </p:blipFill>
          <p:spPr bwMode="auto">
            <a:xfrm>
              <a:off x="2805615" y="1169963"/>
              <a:ext cx="1147808" cy="12223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4" name="Picture 8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808" b="15493"/>
            <a:stretch/>
          </p:blipFill>
          <p:spPr bwMode="auto">
            <a:xfrm>
              <a:off x="3898428" y="1157798"/>
              <a:ext cx="1189494" cy="125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5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4" t="1" r="85963" b="26702"/>
            <a:stretch/>
          </p:blipFill>
          <p:spPr bwMode="auto">
            <a:xfrm>
              <a:off x="519239" y="2185176"/>
              <a:ext cx="1250903" cy="11010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6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28" r="61244" b="26703"/>
            <a:stretch/>
          </p:blipFill>
          <p:spPr bwMode="auto">
            <a:xfrm>
              <a:off x="1665452" y="2194973"/>
              <a:ext cx="1241509" cy="11010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7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64" r="36669" b="26129"/>
            <a:stretch/>
          </p:blipFill>
          <p:spPr bwMode="auto">
            <a:xfrm>
              <a:off x="2799182" y="2186352"/>
              <a:ext cx="1206371" cy="11096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8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666" b="24401"/>
            <a:stretch/>
          </p:blipFill>
          <p:spPr bwMode="auto">
            <a:xfrm>
              <a:off x="3888962" y="2160399"/>
              <a:ext cx="1203117" cy="1135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9" name="Line 9"/>
            <p:cNvSpPr>
              <a:spLocks noChangeShapeType="1"/>
            </p:cNvSpPr>
            <p:nvPr/>
          </p:nvSpPr>
          <p:spPr bwMode="auto">
            <a:xfrm flipV="1">
              <a:off x="564981" y="1546614"/>
              <a:ext cx="0" cy="17526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0" name="Rectangle 89"/>
            <p:cNvSpPr>
              <a:spLocks noChangeArrowheads="1"/>
            </p:cNvSpPr>
            <p:nvPr/>
          </p:nvSpPr>
          <p:spPr bwMode="auto">
            <a:xfrm rot="-5399688">
              <a:off x="33122" y="2293525"/>
              <a:ext cx="795469" cy="3435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/>
              <a:r>
                <a:rPr lang="en-US" altLang="ko-KR" sz="1400" dirty="0">
                  <a:solidFill>
                    <a:srgbClr val="002060"/>
                  </a:solidFill>
                  <a:latin typeface="Arial" charset="0"/>
                  <a:ea typeface="Arial" charset="0"/>
                  <a:cs typeface="Arial" charset="0"/>
                </a:rPr>
                <a:t>Foxp3</a:t>
              </a:r>
            </a:p>
          </p:txBody>
        </p:sp>
        <p:sp>
          <p:nvSpPr>
            <p:cNvPr id="91" name="Line 8"/>
            <p:cNvSpPr>
              <a:spLocks noChangeShapeType="1"/>
            </p:cNvSpPr>
            <p:nvPr/>
          </p:nvSpPr>
          <p:spPr bwMode="auto">
            <a:xfrm>
              <a:off x="564981" y="3299214"/>
              <a:ext cx="1676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2" name="TextBox 13"/>
            <p:cNvSpPr txBox="1">
              <a:spLocks noChangeArrowheads="1"/>
            </p:cNvSpPr>
            <p:nvPr/>
          </p:nvSpPr>
          <p:spPr bwMode="auto">
            <a:xfrm>
              <a:off x="4996522" y="1015386"/>
              <a:ext cx="63030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200" dirty="0">
                  <a:solidFill>
                    <a:srgbClr val="191966"/>
                  </a:solidFill>
                  <a:latin typeface="Arial" charset="0"/>
                  <a:ea typeface="Arial" charset="0"/>
                  <a:cs typeface="Arial" charset="0"/>
                </a:rPr>
                <a:t>TGF-</a:t>
              </a:r>
              <a:r>
                <a:rPr lang="en-US" sz="1200" dirty="0">
                  <a:solidFill>
                    <a:srgbClr val="191966"/>
                  </a:solidFill>
                  <a:latin typeface="Symbol" pitchFamily="2" charset="2"/>
                  <a:ea typeface="Arial" charset="0"/>
                  <a:cs typeface="Arial" charset="0"/>
                </a:rPr>
                <a:t>b</a:t>
              </a:r>
              <a:endParaRPr lang="en-US" sz="1200" i="1" dirty="0">
                <a:solidFill>
                  <a:srgbClr val="191966"/>
                </a:solidFill>
                <a:latin typeface="Symbol" pitchFamily="2" charset="2"/>
                <a:ea typeface="Arial" charset="0"/>
                <a:cs typeface="Arial" charset="0"/>
              </a:endParaRPr>
            </a:p>
          </p:txBody>
        </p:sp>
        <p:sp>
          <p:nvSpPr>
            <p:cNvPr id="93" name="TextBox 13"/>
            <p:cNvSpPr txBox="1">
              <a:spLocks noChangeArrowheads="1"/>
            </p:cNvSpPr>
            <p:nvPr/>
          </p:nvSpPr>
          <p:spPr bwMode="auto">
            <a:xfrm>
              <a:off x="4954199" y="1737396"/>
              <a:ext cx="6447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200" dirty="0">
                  <a:solidFill>
                    <a:srgbClr val="191966"/>
                  </a:solidFill>
                  <a:latin typeface="Arial" charset="0"/>
                  <a:ea typeface="Arial" charset="0"/>
                  <a:cs typeface="Arial" charset="0"/>
                </a:rPr>
                <a:t>0ng/ml</a:t>
              </a:r>
              <a:endParaRPr lang="en-US" sz="1200" i="1" dirty="0">
                <a:solidFill>
                  <a:srgbClr val="191966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4" name="TextBox 13"/>
            <p:cNvSpPr txBox="1">
              <a:spLocks noChangeArrowheads="1"/>
            </p:cNvSpPr>
            <p:nvPr/>
          </p:nvSpPr>
          <p:spPr bwMode="auto">
            <a:xfrm>
              <a:off x="4996522" y="2869228"/>
              <a:ext cx="6447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200" dirty="0">
                  <a:solidFill>
                    <a:srgbClr val="191966"/>
                  </a:solidFill>
                  <a:latin typeface="Arial" charset="0"/>
                  <a:ea typeface="Arial" charset="0"/>
                  <a:cs typeface="Arial" charset="0"/>
                </a:rPr>
                <a:t>2ng/ml</a:t>
              </a:r>
              <a:endParaRPr lang="en-US" sz="1200" i="1" dirty="0">
                <a:solidFill>
                  <a:srgbClr val="191966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8" name="Rectangle 7"/>
            <p:cNvSpPr>
              <a:spLocks noChangeArrowheads="1"/>
            </p:cNvSpPr>
            <p:nvPr/>
          </p:nvSpPr>
          <p:spPr bwMode="auto">
            <a:xfrm>
              <a:off x="1144807" y="3294703"/>
              <a:ext cx="675704" cy="2580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/>
              <a:r>
                <a:rPr lang="en-US" altLang="ko-KR" sz="1400" dirty="0">
                  <a:solidFill>
                    <a:srgbClr val="002060"/>
                  </a:solidFill>
                  <a:latin typeface="Arial" charset="0"/>
                  <a:ea typeface="Arial" charset="0"/>
                  <a:cs typeface="Arial" charset="0"/>
                </a:rPr>
                <a:t>CD4</a:t>
              </a:r>
            </a:p>
          </p:txBody>
        </p:sp>
        <p:sp>
          <p:nvSpPr>
            <p:cNvPr id="55" name="TextBox 15">
              <a:extLst>
                <a:ext uri="{FF2B5EF4-FFF2-40B4-BE49-F238E27FC236}">
                  <a16:creationId xmlns:a16="http://schemas.microsoft.com/office/drawing/2014/main" id="{FCD89CDA-358E-DD46-8355-2ABE4DDC49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29196" y="949299"/>
              <a:ext cx="99899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mad4</a:t>
              </a:r>
              <a:r>
                <a:rPr lang="en-U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15">
              <a:extLst>
                <a:ext uri="{FF2B5EF4-FFF2-40B4-BE49-F238E27FC236}">
                  <a16:creationId xmlns:a16="http://schemas.microsoft.com/office/drawing/2014/main" id="{1CABFCB0-36FF-A843-81CE-3DA68ADAED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2206" y="957237"/>
              <a:ext cx="77938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sz="1400" dirty="0" err="1">
                  <a:latin typeface="Symbol" pitchFamily="2" charset="2"/>
                  <a:cs typeface="Arial" panose="020B0604020202020204" pitchFamily="34" charset="0"/>
                </a:rPr>
                <a:t>g</a:t>
              </a:r>
              <a:r>
                <a:rPr lang="en-US" sz="14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13">
              <a:extLst>
                <a:ext uri="{FF2B5EF4-FFF2-40B4-BE49-F238E27FC236}">
                  <a16:creationId xmlns:a16="http://schemas.microsoft.com/office/drawing/2014/main" id="{76E27D31-8E69-4340-B134-AF91B80DCE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23668" y="958824"/>
              <a:ext cx="46358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15">
              <a:extLst>
                <a:ext uri="{FF2B5EF4-FFF2-40B4-BE49-F238E27FC236}">
                  <a16:creationId xmlns:a16="http://schemas.microsoft.com/office/drawing/2014/main" id="{32DE16E4-8FFF-4B4E-99B5-C184F75AA9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95335" y="957237"/>
              <a:ext cx="57419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DKO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6A5B2723-B328-4E4A-8048-5C9A4646D887}"/>
              </a:ext>
            </a:extLst>
          </p:cNvPr>
          <p:cNvGrpSpPr/>
          <p:nvPr/>
        </p:nvGrpSpPr>
        <p:grpSpPr>
          <a:xfrm>
            <a:off x="339151" y="3621318"/>
            <a:ext cx="3804459" cy="2605043"/>
            <a:chOff x="339151" y="3621318"/>
            <a:chExt cx="3804459" cy="2605043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170C5F5B-8482-A64C-932C-029C7613EE92}"/>
                </a:ext>
              </a:extLst>
            </p:cNvPr>
            <p:cNvGrpSpPr/>
            <p:nvPr/>
          </p:nvGrpSpPr>
          <p:grpSpPr>
            <a:xfrm>
              <a:off x="869837" y="5974542"/>
              <a:ext cx="3003349" cy="251819"/>
              <a:chOff x="1341365" y="6195588"/>
              <a:chExt cx="3303682" cy="277000"/>
            </a:xfrm>
          </p:grpSpPr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EC5664EB-859B-F847-BD17-15A4F191EC6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09376" y="6195588"/>
                <a:ext cx="630301" cy="277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9pPr>
              </a:lstStyle>
              <a:p>
                <a:r>
                  <a:rPr lang="en-US" altLang="en-US" sz="1200" dirty="0">
                    <a:latin typeface="Arial" charset="0"/>
                    <a:ea typeface="Arial" charset="0"/>
                    <a:cs typeface="Arial" charset="0"/>
                  </a:rPr>
                  <a:t>TGF-</a:t>
                </a:r>
                <a:r>
                  <a:rPr lang="en-US" altLang="en-US" sz="1200" dirty="0">
                    <a:latin typeface="Symbol" pitchFamily="2" charset="2"/>
                    <a:ea typeface="Arial" charset="0"/>
                    <a:cs typeface="Arial" charset="0"/>
                  </a:rPr>
                  <a:t>b</a:t>
                </a:r>
              </a:p>
            </p:txBody>
          </p:sp>
          <p:cxnSp>
            <p:nvCxnSpPr>
              <p:cNvPr id="4" name="Straight Connector 3">
                <a:extLst>
                  <a:ext uri="{FF2B5EF4-FFF2-40B4-BE49-F238E27FC236}">
                    <a16:creationId xmlns:a16="http://schemas.microsoft.com/office/drawing/2014/main" id="{6A45A1E3-CD1B-9747-A67D-15AB4ED4D994}"/>
                  </a:ext>
                </a:extLst>
              </p:cNvPr>
              <p:cNvCxnSpPr/>
              <p:nvPr/>
            </p:nvCxnSpPr>
            <p:spPr>
              <a:xfrm>
                <a:off x="3092248" y="6230320"/>
                <a:ext cx="155279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13419BAE-B37B-5748-86CB-2B8C71849DC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29121" y="6195588"/>
                <a:ext cx="866391" cy="277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9pPr>
              </a:lstStyle>
              <a:p>
                <a:r>
                  <a:rPr lang="en-US" altLang="en-US" sz="1200" dirty="0">
                    <a:latin typeface="Arial" charset="0"/>
                    <a:ea typeface="Arial" charset="0"/>
                    <a:cs typeface="Arial" charset="0"/>
                  </a:rPr>
                  <a:t>No TGF-</a:t>
                </a:r>
                <a:r>
                  <a:rPr lang="en-US" altLang="en-US" sz="1200" dirty="0">
                    <a:latin typeface="Symbol" pitchFamily="2" charset="2"/>
                    <a:ea typeface="Arial" charset="0"/>
                    <a:cs typeface="Arial" charset="0"/>
                  </a:rPr>
                  <a:t>b</a:t>
                </a:r>
              </a:p>
            </p:txBody>
          </p:sp>
          <p:cxnSp>
            <p:nvCxnSpPr>
              <p:cNvPr id="99" name="Straight Connector 98">
                <a:extLst>
                  <a:ext uri="{FF2B5EF4-FFF2-40B4-BE49-F238E27FC236}">
                    <a16:creationId xmlns:a16="http://schemas.microsoft.com/office/drawing/2014/main" id="{64E8A03A-82D2-834E-82F2-4D1BCD2E82D7}"/>
                  </a:ext>
                </a:extLst>
              </p:cNvPr>
              <p:cNvCxnSpPr/>
              <p:nvPr/>
            </p:nvCxnSpPr>
            <p:spPr>
              <a:xfrm>
                <a:off x="1341365" y="6230340"/>
                <a:ext cx="155279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4C8438F8-EC0F-0749-80B6-51708F0466C6}"/>
                </a:ext>
              </a:extLst>
            </p:cNvPr>
            <p:cNvGrpSpPr/>
            <p:nvPr/>
          </p:nvGrpSpPr>
          <p:grpSpPr>
            <a:xfrm>
              <a:off x="339151" y="3621318"/>
              <a:ext cx="3804459" cy="2430930"/>
              <a:chOff x="339151" y="3621318"/>
              <a:chExt cx="3804459" cy="2430930"/>
            </a:xfrm>
          </p:grpSpPr>
          <p:graphicFrame>
            <p:nvGraphicFramePr>
              <p:cNvPr id="59" name="Chart 58">
                <a:extLst>
                  <a:ext uri="{FF2B5EF4-FFF2-40B4-BE49-F238E27FC236}">
                    <a16:creationId xmlns:a16="http://schemas.microsoft.com/office/drawing/2014/main" id="{00000000-0008-0000-0100-00000600000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68589671"/>
                  </p:ext>
                </p:extLst>
              </p:nvPr>
            </p:nvGraphicFramePr>
            <p:xfrm>
              <a:off x="339151" y="3621318"/>
              <a:ext cx="3804459" cy="243093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00" name="TextBox 74">
                <a:extLst>
                  <a:ext uri="{FF2B5EF4-FFF2-40B4-BE49-F238E27FC236}">
                    <a16:creationId xmlns:a16="http://schemas.microsoft.com/office/drawing/2014/main" id="{94FC70EB-4AE7-AF49-8AFF-168228B7C7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95927" y="3857679"/>
                <a:ext cx="349933" cy="2017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1pPr>
                <a:lvl2pPr marL="742950" indent="-285750"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2pPr>
                <a:lvl3pPr marL="1143000" indent="-228600"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3pPr>
                <a:lvl4pPr marL="1600200" indent="-228600"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4pPr>
                <a:lvl5pPr marL="2057400" indent="-228600"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5pPr>
                <a:lvl6pPr marL="2514600" indent="-228600" eaLnBrk="0" fontAlgn="base" latinLnBrk="1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6pPr>
                <a:lvl7pPr marL="2971800" indent="-228600" eaLnBrk="0" fontAlgn="base" latinLnBrk="1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7pPr>
                <a:lvl8pPr marL="3429000" indent="-228600" eaLnBrk="0" fontAlgn="base" latinLnBrk="1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8pPr>
                <a:lvl9pPr marL="3886200" indent="-228600" eaLnBrk="0" fontAlgn="base" latinLnBrk="1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9pPr>
              </a:lstStyle>
              <a:p>
                <a:pPr eaLnBrk="1" hangingPunct="1"/>
                <a:r>
                  <a:rPr lang="en-US" sz="1400" dirty="0">
                    <a:latin typeface="Arial" charset="0"/>
                    <a:cs typeface="Arial" charset="0"/>
                  </a:rPr>
                  <a:t>**</a:t>
                </a:r>
              </a:p>
            </p:txBody>
          </p:sp>
          <p:sp>
            <p:nvSpPr>
              <p:cNvPr id="101" name="Left Bracket 100">
                <a:extLst>
                  <a:ext uri="{FF2B5EF4-FFF2-40B4-BE49-F238E27FC236}">
                    <a16:creationId xmlns:a16="http://schemas.microsoft.com/office/drawing/2014/main" id="{5096714B-58F5-2542-BFA8-ABED1448CF0C}"/>
                  </a:ext>
                </a:extLst>
              </p:cNvPr>
              <p:cNvSpPr/>
              <p:nvPr/>
            </p:nvSpPr>
            <p:spPr bwMode="auto">
              <a:xfrm rot="5400000">
                <a:off x="2820442" y="3870147"/>
                <a:ext cx="30557" cy="365176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lIns="82058" tIns="41029" rIns="82058" bIns="41029" anchor="ctr"/>
              <a:lstStyle/>
              <a:p>
                <a:pPr algn="ctr" eaLnBrk="1" hangingPunct="1"/>
                <a:endParaRPr lang="en-US">
                  <a:latin typeface="Arial" charset="0"/>
                  <a:ea typeface="MS PGothic" charset="0"/>
                  <a:cs typeface="MS PGothic" charset="0"/>
                </a:endParaRPr>
              </a:p>
            </p:txBody>
          </p:sp>
          <p:sp>
            <p:nvSpPr>
              <p:cNvPr id="102" name="TextBox 74">
                <a:extLst>
                  <a:ext uri="{FF2B5EF4-FFF2-40B4-BE49-F238E27FC236}">
                    <a16:creationId xmlns:a16="http://schemas.microsoft.com/office/drawing/2014/main" id="{BA31BCE6-60E8-0444-8D85-7282C632F01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52418" y="3726427"/>
                <a:ext cx="349933" cy="2017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1pPr>
                <a:lvl2pPr marL="742950" indent="-285750"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2pPr>
                <a:lvl3pPr marL="1143000" indent="-228600"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3pPr>
                <a:lvl4pPr marL="1600200" indent="-228600"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4pPr>
                <a:lvl5pPr marL="2057400" indent="-228600" eaLnBrk="0" hangingPunct="0"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5pPr>
                <a:lvl6pPr marL="2514600" indent="-228600" eaLnBrk="0" fontAlgn="base" latinLnBrk="1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6pPr>
                <a:lvl7pPr marL="2971800" indent="-228600" eaLnBrk="0" fontAlgn="base" latinLnBrk="1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7pPr>
                <a:lvl8pPr marL="3429000" indent="-228600" eaLnBrk="0" fontAlgn="base" latinLnBrk="1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8pPr>
                <a:lvl9pPr marL="3886200" indent="-228600" eaLnBrk="0" fontAlgn="base" latinLnBrk="1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굴림" charset="0"/>
                    <a:ea typeface="굴림" charset="0"/>
                    <a:cs typeface="굴림" charset="0"/>
                  </a:defRPr>
                </a:lvl9pPr>
              </a:lstStyle>
              <a:p>
                <a:pPr eaLnBrk="1" hangingPunct="1"/>
                <a:r>
                  <a:rPr lang="en-US" sz="1400" dirty="0">
                    <a:latin typeface="Arial" charset="0"/>
                    <a:cs typeface="Arial" charset="0"/>
                  </a:rPr>
                  <a:t>**</a:t>
                </a:r>
              </a:p>
            </p:txBody>
          </p:sp>
          <p:sp>
            <p:nvSpPr>
              <p:cNvPr id="103" name="Left Bracket 102">
                <a:extLst>
                  <a:ext uri="{FF2B5EF4-FFF2-40B4-BE49-F238E27FC236}">
                    <a16:creationId xmlns:a16="http://schemas.microsoft.com/office/drawing/2014/main" id="{878DE3E4-F3BB-8246-9113-728667BFB9C5}"/>
                  </a:ext>
                </a:extLst>
              </p:cNvPr>
              <p:cNvSpPr/>
              <p:nvPr/>
            </p:nvSpPr>
            <p:spPr bwMode="auto">
              <a:xfrm rot="5400000">
                <a:off x="3592893" y="3738895"/>
                <a:ext cx="30557" cy="365176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lIns="82058" tIns="41029" rIns="82058" bIns="41029" anchor="ctr"/>
              <a:lstStyle/>
              <a:p>
                <a:pPr algn="ctr" eaLnBrk="1" hangingPunct="1"/>
                <a:endParaRPr lang="en-US">
                  <a:latin typeface="Arial" charset="0"/>
                  <a:ea typeface="MS PGothic" charset="0"/>
                  <a:cs typeface="MS PGothic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540628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3"/>
          <p:cNvSpPr>
            <a:spLocks noChangeArrowheads="1"/>
          </p:cNvSpPr>
          <p:nvPr/>
        </p:nvSpPr>
        <p:spPr bwMode="auto">
          <a:xfrm>
            <a:off x="6751" y="6750"/>
            <a:ext cx="3055012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579438" indent="-579438" algn="ctr" latinLnBrk="0">
              <a:spcBef>
                <a:spcPct val="20000"/>
              </a:spcBef>
            </a:pPr>
            <a:r>
              <a:rPr lang="en-US" altLang="ko-KR" dirty="0">
                <a:solidFill>
                  <a:srgbClr val="003366"/>
                </a:solidFill>
                <a:latin typeface="Arial" charset="0"/>
              </a:rPr>
              <a:t>Supplementary F</a:t>
            </a:r>
            <a:r>
              <a:rPr kumimoji="0" lang="en-US" altLang="ko-KR" sz="1800" dirty="0">
                <a:solidFill>
                  <a:srgbClr val="003366"/>
                </a:solidFill>
                <a:latin typeface="Arial" charset="0"/>
              </a:rPr>
              <a:t>igure </a:t>
            </a:r>
            <a:r>
              <a:rPr lang="en-US" altLang="ko-KR" dirty="0">
                <a:solidFill>
                  <a:srgbClr val="003366"/>
                </a:solidFill>
                <a:latin typeface="Arial" charset="0"/>
              </a:rPr>
              <a:t>4</a:t>
            </a:r>
            <a:endParaRPr kumimoji="0" lang="en-US" altLang="ko-KR" sz="1800" dirty="0">
              <a:solidFill>
                <a:srgbClr val="003366"/>
              </a:solidFill>
              <a:latin typeface="Arial" charset="0"/>
            </a:endParaRPr>
          </a:p>
        </p:txBody>
      </p:sp>
      <p:sp>
        <p:nvSpPr>
          <p:cNvPr id="204" name="TextBox 203"/>
          <p:cNvSpPr txBox="1">
            <a:spLocks noChangeArrowheads="1"/>
          </p:cNvSpPr>
          <p:nvPr/>
        </p:nvSpPr>
        <p:spPr bwMode="auto">
          <a:xfrm>
            <a:off x="194728" y="855702"/>
            <a:ext cx="3635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US" sz="1800" b="1" dirty="0"/>
              <a:t>A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309D7D9-9E3A-694B-B40A-A69468C66AD5}"/>
              </a:ext>
            </a:extLst>
          </p:cNvPr>
          <p:cNvGrpSpPr/>
          <p:nvPr/>
        </p:nvGrpSpPr>
        <p:grpSpPr>
          <a:xfrm>
            <a:off x="558906" y="1040368"/>
            <a:ext cx="3725428" cy="2743199"/>
            <a:chOff x="558906" y="1040368"/>
            <a:chExt cx="3725428" cy="2743199"/>
          </a:xfrm>
        </p:grpSpPr>
        <p:graphicFrame>
          <p:nvGraphicFramePr>
            <p:cNvPr id="36" name="Chart 35">
              <a:extLst>
                <a:ext uri="{FF2B5EF4-FFF2-40B4-BE49-F238E27FC236}">
                  <a16:creationId xmlns:a16="http://schemas.microsoft.com/office/drawing/2014/main" id="{342C3E6E-52B7-B54F-B41E-5E2C7DCFB53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39154850"/>
                </p:ext>
              </p:extLst>
            </p:nvPr>
          </p:nvGraphicFramePr>
          <p:xfrm>
            <a:off x="558906" y="1040368"/>
            <a:ext cx="3725428" cy="27431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7" name="TextBox 74">
              <a:extLst>
                <a:ext uri="{FF2B5EF4-FFF2-40B4-BE49-F238E27FC236}">
                  <a16:creationId xmlns:a16="http://schemas.microsoft.com/office/drawing/2014/main" id="{05CE13FF-E93A-474E-9F21-D295844ECA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74487" y="1341472"/>
              <a:ext cx="423419" cy="244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5pPr>
              <a:lvl6pPr marL="25146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6pPr>
              <a:lvl7pPr marL="29718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7pPr>
              <a:lvl8pPr marL="34290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8pPr>
              <a:lvl9pPr marL="3886200" indent="-228600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굴림" charset="0"/>
                  <a:ea typeface="굴림" charset="0"/>
                  <a:cs typeface="굴림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charset="0"/>
                  <a:cs typeface="Arial" charset="0"/>
                </a:rPr>
                <a:t>*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72931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899</TotalTime>
  <Words>143</Words>
  <Application>Microsoft Macintosh PowerPoint</Application>
  <PresentationFormat>Letter Paper (8.5x11 in)</PresentationFormat>
  <Paragraphs>82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yung-Gyu Kim</dc:creator>
  <cp:lastModifiedBy>Byung-Gyu Kim</cp:lastModifiedBy>
  <cp:revision>107</cp:revision>
  <cp:lastPrinted>2022-04-20T18:31:15Z</cp:lastPrinted>
  <dcterms:created xsi:type="dcterms:W3CDTF">2022-01-15T21:21:02Z</dcterms:created>
  <dcterms:modified xsi:type="dcterms:W3CDTF">2022-07-22T19:33:33Z</dcterms:modified>
</cp:coreProperties>
</file>